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6"/>
  </p:notesMasterIdLst>
  <p:sldIdLst>
    <p:sldId id="266" r:id="rId2"/>
    <p:sldId id="268" r:id="rId3"/>
    <p:sldId id="270" r:id="rId4"/>
    <p:sldId id="265" r:id="rId5"/>
  </p:sldIdLst>
  <p:sldSz cx="7772400" cy="10058400"/>
  <p:notesSz cx="7315200" cy="9601200"/>
  <p:embeddedFontLst>
    <p:embeddedFont>
      <p:font typeface="Calibri" panose="020F0502020204030204" pitchFamily="34" charset="0"/>
      <p:regular r:id="rId7"/>
      <p:bold r:id="rId8"/>
      <p:italic r:id="rId9"/>
      <p:boldItalic r:id="rId10"/>
    </p:embeddedFont>
  </p:embeddedFontLst>
  <p:defaultTextStyle>
    <a:defPPr>
      <a:defRPr lang="en-US"/>
    </a:defPPr>
    <a:lvl1pPr marL="0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1pPr>
    <a:lvl2pPr marL="285293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2pPr>
    <a:lvl3pPr marL="570586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3pPr>
    <a:lvl4pPr marL="855878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4pPr>
    <a:lvl5pPr marL="1141171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5pPr>
    <a:lvl6pPr marL="1426464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6pPr>
    <a:lvl7pPr marL="1711757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7pPr>
    <a:lvl8pPr marL="1997050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8pPr>
    <a:lvl9pPr marL="2282342" algn="l" defTabSz="570586" rtl="0" eaLnBrk="1" latinLnBrk="0" hangingPunct="1">
      <a:defRPr sz="112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2" userDrawn="1">
          <p15:clr>
            <a:srgbClr val="A4A3A4"/>
          </p15:clr>
        </p15:guide>
        <p15:guide id="2" pos="1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0563"/>
    <a:srgbClr val="C35E59"/>
    <a:srgbClr val="D28280"/>
    <a:srgbClr val="FCDDC4"/>
    <a:srgbClr val="FABA86"/>
    <a:srgbClr val="FACDA8"/>
    <a:srgbClr val="F8A662"/>
    <a:srgbClr val="F7944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 autoAdjust="0"/>
    <p:restoredTop sz="94558" autoAdjust="0"/>
  </p:normalViewPr>
  <p:slideViewPr>
    <p:cSldViewPr>
      <p:cViewPr varScale="1">
        <p:scale>
          <a:sx n="56" d="100"/>
          <a:sy n="56" d="100"/>
        </p:scale>
        <p:origin x="2458" y="38"/>
      </p:cViewPr>
      <p:guideLst>
        <p:guide orient="horz" pos="2112"/>
        <p:guide pos="122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2.fntdata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font" Target="fonts/font1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font" Target="fonts/font4.fntdata"/><Relationship Id="rId4" Type="http://schemas.openxmlformats.org/officeDocument/2006/relationships/slide" Target="slides/slide3.xml"/><Relationship Id="rId9" Type="http://schemas.openxmlformats.org/officeDocument/2006/relationships/font" Target="fonts/font3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C52964CA-2508-D340-8ECB-8EB8EA611EF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200150"/>
            <a:ext cx="25050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1AFC56C6-74AC-744D-840E-D59387646F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796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1pPr>
    <a:lvl2pPr marL="285293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2pPr>
    <a:lvl3pPr marL="570586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3pPr>
    <a:lvl4pPr marL="855878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4pPr>
    <a:lvl5pPr marL="1141171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5pPr>
    <a:lvl6pPr marL="1426464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6pPr>
    <a:lvl7pPr marL="1711757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7pPr>
    <a:lvl8pPr marL="1997050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8pPr>
    <a:lvl9pPr marL="2282342" algn="l" defTabSz="570586" rtl="0" eaLnBrk="1" latinLnBrk="0" hangingPunct="1">
      <a:defRPr sz="74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91466" y="2083083"/>
            <a:ext cx="3303270" cy="143735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2930" y="3799840"/>
            <a:ext cx="2720340" cy="171365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817495" y="268536"/>
            <a:ext cx="874395" cy="57214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4310" y="268536"/>
            <a:ext cx="2558415" cy="57214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6983" y="4308970"/>
            <a:ext cx="3303270" cy="1331807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983" y="2842121"/>
            <a:ext cx="3303270" cy="14668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4311" y="1564640"/>
            <a:ext cx="1716405" cy="4425386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5485" y="1564640"/>
            <a:ext cx="1716405" cy="4425386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4310" y="1501000"/>
            <a:ext cx="1717080" cy="625545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4310" y="2126544"/>
            <a:ext cx="1717080" cy="3863482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974136" y="1501000"/>
            <a:ext cx="1717754" cy="625545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974136" y="2126544"/>
            <a:ext cx="1717754" cy="3863482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310" y="266982"/>
            <a:ext cx="1278533" cy="1136227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19397" y="266982"/>
            <a:ext cx="2172493" cy="5723044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310" y="1403210"/>
            <a:ext cx="1278533" cy="4586817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1722" y="4693920"/>
            <a:ext cx="2331720" cy="554144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61722" y="599158"/>
            <a:ext cx="2331720" cy="402336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1722" y="5248064"/>
            <a:ext cx="2331720" cy="786976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4310" y="268535"/>
            <a:ext cx="3497580" cy="1117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4310" y="1564640"/>
            <a:ext cx="3497580" cy="44253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4310" y="6215099"/>
            <a:ext cx="906780" cy="3570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27786" y="6215099"/>
            <a:ext cx="1230630" cy="3570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785110" y="6215099"/>
            <a:ext cx="906780" cy="3570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0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0" hangingPunct="1">
        <a:spcBef>
          <a:spcPct val="20000"/>
        </a:spcBef>
        <a:buFont typeface="Arial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0" hangingPunct="1">
        <a:spcBef>
          <a:spcPct val="20000"/>
        </a:spcBef>
        <a:buFont typeface="Arial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spcBef>
          <a:spcPct val="20000"/>
        </a:spcBef>
        <a:buFont typeface="Arial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spcBef>
          <a:spcPct val="20000"/>
        </a:spcBef>
        <a:buFont typeface="Arial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2.png"/><Relationship Id="rId7" Type="http://schemas.openxmlformats.org/officeDocument/2006/relationships/image" Target="../media/image13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openxmlformats.org/officeDocument/2006/relationships/image" Target="../media/image11.png"/><Relationship Id="rId5" Type="http://schemas.openxmlformats.org/officeDocument/2006/relationships/image" Target="../media/image10.png"/><Relationship Id="rId10" Type="http://schemas.openxmlformats.org/officeDocument/2006/relationships/image" Target="../media/image5.png"/><Relationship Id="rId4" Type="http://schemas.openxmlformats.org/officeDocument/2006/relationships/image" Target="../media/image3.png"/><Relationship Id="rId9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1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" Type="http://schemas.openxmlformats.org/officeDocument/2006/relationships/image" Target="../media/image10.png"/><Relationship Id="rId16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5" Type="http://schemas.openxmlformats.org/officeDocument/2006/relationships/image" Target="../media/image2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38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12" Type="http://schemas.openxmlformats.org/officeDocument/2006/relationships/image" Target="../media/image37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11" Type="http://schemas.openxmlformats.org/officeDocument/2006/relationships/image" Target="../media/image3.png"/><Relationship Id="rId5" Type="http://schemas.openxmlformats.org/officeDocument/2006/relationships/image" Target="../media/image32.png"/><Relationship Id="rId15" Type="http://schemas.openxmlformats.org/officeDocument/2006/relationships/image" Target="../media/image11.png"/><Relationship Id="rId10" Type="http://schemas.openxmlformats.org/officeDocument/2006/relationships/image" Target="../media/image2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Relationship Id="rId1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6D1A73E-4F8B-4E12-B746-B100CBEFD6CB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80316" y="7715247"/>
            <a:ext cx="1012338" cy="116002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C01B4F5-D221-47B7-902C-1C7CF0E14C55}"/>
              </a:ext>
            </a:extLst>
          </p:cNvPr>
          <p:cNvSpPr txBox="1"/>
          <p:nvPr/>
        </p:nvSpPr>
        <p:spPr>
          <a:xfrm>
            <a:off x="2404330" y="7436141"/>
            <a:ext cx="5176322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2500" b="1" dirty="0"/>
              <a:t>Keep your mask on during the duration of your appointment, removing only when the doctor asks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1BF70B3-25F5-4D11-B42C-FBE143BB90A3}"/>
              </a:ext>
            </a:extLst>
          </p:cNvPr>
          <p:cNvGrpSpPr/>
          <p:nvPr/>
        </p:nvGrpSpPr>
        <p:grpSpPr>
          <a:xfrm>
            <a:off x="1518211" y="7696836"/>
            <a:ext cx="1369296" cy="1276865"/>
            <a:chOff x="9810226" y="3586001"/>
            <a:chExt cx="2895611" cy="2701382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C4863DDE-C306-49D6-AB79-F5E65528C085}"/>
                </a:ext>
              </a:extLst>
            </p:cNvPr>
            <p:cNvGrpSpPr/>
            <p:nvPr/>
          </p:nvGrpSpPr>
          <p:grpSpPr>
            <a:xfrm>
              <a:off x="9810226" y="3586001"/>
              <a:ext cx="2895611" cy="2701382"/>
              <a:chOff x="14437305" y="1724101"/>
              <a:chExt cx="3810000" cy="3810000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155234B5-35F6-4B8C-89E2-BC2D3790B1FF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057019" y="1724101"/>
                <a:ext cx="2570571" cy="2701382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4FD2F853-A969-485A-9BDE-3BE909C9CAD2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437305" y="1724101"/>
                <a:ext cx="3810000" cy="3810000"/>
              </a:xfrm>
              <a:prstGeom prst="rect">
                <a:avLst/>
              </a:prstGeom>
            </p:spPr>
          </p:pic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96D7934E-D5AB-46A7-BCBF-C17F6FC8168B}"/>
                  </a:ext>
                </a:extLst>
              </p:cNvPr>
              <p:cNvGrpSpPr/>
              <p:nvPr/>
            </p:nvGrpSpPr>
            <p:grpSpPr>
              <a:xfrm>
                <a:off x="15770804" y="3030104"/>
                <a:ext cx="1143000" cy="1197993"/>
                <a:chOff x="12649200" y="3564507"/>
                <a:chExt cx="1143000" cy="1197993"/>
              </a:xfrm>
            </p:grpSpPr>
            <p:sp>
              <p:nvSpPr>
                <p:cNvPr id="24" name="Oval 23">
                  <a:extLst>
                    <a:ext uri="{FF2B5EF4-FFF2-40B4-BE49-F238E27FC236}">
                      <a16:creationId xmlns:a16="http://schemas.microsoft.com/office/drawing/2014/main" id="{B871C2AD-CD8E-41EB-AB95-750ABEF3AB10}"/>
                    </a:ext>
                  </a:extLst>
                </p:cNvPr>
                <p:cNvSpPr/>
                <p:nvPr/>
              </p:nvSpPr>
              <p:spPr>
                <a:xfrm>
                  <a:off x="12649200" y="3564507"/>
                  <a:ext cx="1143000" cy="1197993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  <p:cxnSp>
              <p:nvCxnSpPr>
                <p:cNvPr id="25" name="Straight Connector 24">
                  <a:extLst>
                    <a:ext uri="{FF2B5EF4-FFF2-40B4-BE49-F238E27FC236}">
                      <a16:creationId xmlns:a16="http://schemas.microsoft.com/office/drawing/2014/main" id="{084C6A4D-A683-4229-BB85-9F0EACBDE687}"/>
                    </a:ext>
                  </a:extLst>
                </p:cNvPr>
                <p:cNvCxnSpPr/>
                <p:nvPr/>
              </p:nvCxnSpPr>
              <p:spPr>
                <a:xfrm>
                  <a:off x="12954000" y="3894696"/>
                  <a:ext cx="4572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>
                  <a:extLst>
                    <a:ext uri="{FF2B5EF4-FFF2-40B4-BE49-F238E27FC236}">
                      <a16:creationId xmlns:a16="http://schemas.microsoft.com/office/drawing/2014/main" id="{94E68BD1-1E7F-4E17-977F-28B541254704}"/>
                    </a:ext>
                  </a:extLst>
                </p:cNvPr>
                <p:cNvCxnSpPr/>
                <p:nvPr/>
              </p:nvCxnSpPr>
              <p:spPr>
                <a:xfrm>
                  <a:off x="12954000" y="4474206"/>
                  <a:ext cx="4572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F5EFAAC0-3A5B-4033-B57F-AF57C7E758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877800" y="4076700"/>
                  <a:ext cx="6858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78C289B8-45B9-4BD0-B44F-D3E150D7F3C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787312" y="4305300"/>
                  <a:ext cx="852488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0" name="Rectangle: Top Corners Snipped 19">
              <a:extLst>
                <a:ext uri="{FF2B5EF4-FFF2-40B4-BE49-F238E27FC236}">
                  <a16:creationId xmlns:a16="http://schemas.microsoft.com/office/drawing/2014/main" id="{60862EB8-6A53-424A-9FA7-B919DD981A9B}"/>
                </a:ext>
              </a:extLst>
            </p:cNvPr>
            <p:cNvSpPr/>
            <p:nvPr/>
          </p:nvSpPr>
          <p:spPr>
            <a:xfrm>
              <a:off x="10649565" y="3882102"/>
              <a:ext cx="1219200" cy="1515676"/>
            </a:xfrm>
            <a:prstGeom prst="snip2Same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540F6094-AAC9-4CEA-B723-9B6D9B3BFC5F}"/>
              </a:ext>
            </a:extLst>
          </p:cNvPr>
          <p:cNvGrpSpPr/>
          <p:nvPr/>
        </p:nvGrpSpPr>
        <p:grpSpPr>
          <a:xfrm>
            <a:off x="214854" y="4993616"/>
            <a:ext cx="3380218" cy="2286876"/>
            <a:chOff x="327777" y="4395246"/>
            <a:chExt cx="3834860" cy="2618382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B3B502E1-CFA6-43F5-BF20-F3B92D638A24}"/>
                </a:ext>
              </a:extLst>
            </p:cNvPr>
            <p:cNvGrpSpPr/>
            <p:nvPr/>
          </p:nvGrpSpPr>
          <p:grpSpPr>
            <a:xfrm>
              <a:off x="327777" y="4395246"/>
              <a:ext cx="3424713" cy="2261014"/>
              <a:chOff x="862762" y="3951699"/>
              <a:chExt cx="6041361" cy="3810000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E8FECB65-D598-42E2-8CB9-0CEA7CC52443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04207" y="3951699"/>
                <a:ext cx="3809999" cy="381000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09CA543F-065A-4979-BC4E-B380CE2D384F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62762" y="5310987"/>
                <a:ext cx="2274831" cy="2179856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E891D292-5669-4995-ACA6-72DD9E0680C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36288" t="46000"/>
              <a:stretch/>
            </p:blipFill>
            <p:spPr>
              <a:xfrm>
                <a:off x="4291761" y="5704299"/>
                <a:ext cx="2427445" cy="205740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A3EAABD7-2AEC-489C-9F1F-9C892586BC8B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629292" y="5310987"/>
                <a:ext cx="2274831" cy="2179856"/>
              </a:xfrm>
              <a:prstGeom prst="rect">
                <a:avLst/>
              </a:prstGeom>
            </p:spPr>
          </p:pic>
        </p:grp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2827FBD3-6B10-4498-B340-FA25BBA0EE97}"/>
                </a:ext>
              </a:extLst>
            </p:cNvPr>
            <p:cNvCxnSpPr>
              <a:cxnSpLocks/>
            </p:cNvCxnSpPr>
            <p:nvPr/>
          </p:nvCxnSpPr>
          <p:spPr>
            <a:xfrm>
              <a:off x="1229934" y="6485232"/>
              <a:ext cx="1655429" cy="0"/>
            </a:xfrm>
            <a:prstGeom prst="straightConnector1">
              <a:avLst/>
            </a:prstGeom>
            <a:ln w="76200">
              <a:solidFill>
                <a:srgbClr val="FF000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7DC4327-5D7B-495C-8F75-6360D73BA3D6}"/>
                </a:ext>
              </a:extLst>
            </p:cNvPr>
            <p:cNvSpPr txBox="1"/>
            <p:nvPr/>
          </p:nvSpPr>
          <p:spPr>
            <a:xfrm>
              <a:off x="1735192" y="6459630"/>
              <a:ext cx="242744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3000" b="1" dirty="0"/>
                <a:t>2 m 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75D63755-80F4-496E-97D4-3A4D4E74FD3F}"/>
              </a:ext>
            </a:extLst>
          </p:cNvPr>
          <p:cNvSpPr txBox="1"/>
          <p:nvPr/>
        </p:nvSpPr>
        <p:spPr>
          <a:xfrm>
            <a:off x="2891791" y="5357395"/>
            <a:ext cx="435341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2500" b="1" dirty="0"/>
              <a:t>Please practice social distancing and try to maintain a distance of 2 meters from those around you 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86DD914-84B7-4C43-AFC0-D40CE7157D40}"/>
              </a:ext>
            </a:extLst>
          </p:cNvPr>
          <p:cNvSpPr/>
          <p:nvPr/>
        </p:nvSpPr>
        <p:spPr>
          <a:xfrm>
            <a:off x="261572" y="5221854"/>
            <a:ext cx="7207720" cy="209796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0DFD4BC-2835-4546-A175-887ED87F83A3}"/>
              </a:ext>
            </a:extLst>
          </p:cNvPr>
          <p:cNvSpPr/>
          <p:nvPr/>
        </p:nvSpPr>
        <p:spPr>
          <a:xfrm>
            <a:off x="285529" y="7467838"/>
            <a:ext cx="7183761" cy="159392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273354AF-604A-43BB-A42B-3E51E024278C}"/>
              </a:ext>
            </a:extLst>
          </p:cNvPr>
          <p:cNvGrpSpPr/>
          <p:nvPr/>
        </p:nvGrpSpPr>
        <p:grpSpPr>
          <a:xfrm>
            <a:off x="289666" y="1028678"/>
            <a:ext cx="8010363" cy="3434085"/>
            <a:chOff x="395953" y="393919"/>
            <a:chExt cx="8010363" cy="343408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12D5DC6-49BB-4ABB-A029-389D14069E65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5953" y="1210050"/>
              <a:ext cx="1625457" cy="1475823"/>
            </a:xfrm>
            <a:prstGeom prst="rect">
              <a:avLst/>
            </a:prstGeom>
          </p:spPr>
        </p:pic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DF07E004-5668-4384-BE49-BC2869D2D7E1}"/>
                </a:ext>
              </a:extLst>
            </p:cNvPr>
            <p:cNvSpPr/>
            <p:nvPr/>
          </p:nvSpPr>
          <p:spPr>
            <a:xfrm>
              <a:off x="2418268" y="1295400"/>
              <a:ext cx="1370196" cy="1281018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0C04C21C-41AD-42DD-9065-A5F55BA35036}"/>
                </a:ext>
              </a:extLst>
            </p:cNvPr>
            <p:cNvSpPr/>
            <p:nvPr/>
          </p:nvSpPr>
          <p:spPr>
            <a:xfrm>
              <a:off x="4196512" y="1241133"/>
              <a:ext cx="1444947" cy="1335285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9FDD9510-7346-4C6D-9174-271965BFA2C6}"/>
                </a:ext>
              </a:extLst>
            </p:cNvPr>
            <p:cNvSpPr/>
            <p:nvPr/>
          </p:nvSpPr>
          <p:spPr>
            <a:xfrm>
              <a:off x="5897360" y="1241133"/>
              <a:ext cx="1376634" cy="1335285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66B3E36-3F2B-489C-9961-E40631CD02A3}"/>
                </a:ext>
              </a:extLst>
            </p:cNvPr>
            <p:cNvSpPr txBox="1"/>
            <p:nvPr/>
          </p:nvSpPr>
          <p:spPr>
            <a:xfrm>
              <a:off x="2266119" y="833150"/>
              <a:ext cx="1778245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500" b="1" dirty="0"/>
                <a:t>FEVER 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7D582A0-04C2-4288-A29E-7CA3EA940979}"/>
                </a:ext>
              </a:extLst>
            </p:cNvPr>
            <p:cNvSpPr txBox="1"/>
            <p:nvPr/>
          </p:nvSpPr>
          <p:spPr>
            <a:xfrm>
              <a:off x="4037791" y="770786"/>
              <a:ext cx="1778245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500" b="1" dirty="0"/>
                <a:t>COUGH 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E8CEBA1-93A5-41EA-B196-F885AC0A3FCD}"/>
                </a:ext>
              </a:extLst>
            </p:cNvPr>
            <p:cNvSpPr txBox="1"/>
            <p:nvPr/>
          </p:nvSpPr>
          <p:spPr>
            <a:xfrm>
              <a:off x="5755404" y="393919"/>
              <a:ext cx="1778245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500" b="1" dirty="0"/>
                <a:t>SHORTNESS OF BREATH 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95A9EA5-6C41-4F1F-9083-97C4D19F2D0F}"/>
                </a:ext>
              </a:extLst>
            </p:cNvPr>
            <p:cNvSpPr/>
            <p:nvPr/>
          </p:nvSpPr>
          <p:spPr>
            <a:xfrm>
              <a:off x="422929" y="3024449"/>
              <a:ext cx="7152649" cy="803555"/>
            </a:xfrm>
            <a:prstGeom prst="rect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3000" b="1" dirty="0"/>
                <a:t>PLEASE DO NOT ENTER CLINIC 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A72CD2D-392B-4D61-AB7F-5375E0405DF8}"/>
                </a:ext>
              </a:extLst>
            </p:cNvPr>
            <p:cNvSpPr txBox="1"/>
            <p:nvPr/>
          </p:nvSpPr>
          <p:spPr>
            <a:xfrm flipH="1">
              <a:off x="992772" y="2558004"/>
              <a:ext cx="7413544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500" b="1" dirty="0"/>
                <a:t>OR IF YOU HAVE BEEN EXPOSED TO COVID-19</a:t>
              </a:r>
            </a:p>
          </p:txBody>
        </p:sp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6F5E9945-590C-4048-AE01-D3F66FB1CBA0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610502" y="1433958"/>
              <a:ext cx="1090857" cy="962801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7E0D807A-146A-4071-9FEE-C435DC11A989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299735" y="1385742"/>
              <a:ext cx="1256645" cy="1016492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A4CB17B3-E694-46EC-937B-0120929D09F9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096000" y="1435680"/>
              <a:ext cx="1048027" cy="936022"/>
            </a:xfrm>
            <a:prstGeom prst="rect">
              <a:avLst/>
            </a:prstGeom>
          </p:spPr>
        </p:pic>
      </p:grpSp>
      <p:sp>
        <p:nvSpPr>
          <p:cNvPr id="57" name="Rectangle 56">
            <a:extLst>
              <a:ext uri="{FF2B5EF4-FFF2-40B4-BE49-F238E27FC236}">
                <a16:creationId xmlns:a16="http://schemas.microsoft.com/office/drawing/2014/main" id="{F33C22C8-3E5C-444F-B16A-1C9903D37B40}"/>
              </a:ext>
            </a:extLst>
          </p:cNvPr>
          <p:cNvSpPr/>
          <p:nvPr/>
        </p:nvSpPr>
        <p:spPr>
          <a:xfrm>
            <a:off x="261572" y="227876"/>
            <a:ext cx="7207719" cy="728309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E4F2E79-9123-42E8-87E9-8D5B0F981FFE}"/>
              </a:ext>
            </a:extLst>
          </p:cNvPr>
          <p:cNvSpPr txBox="1"/>
          <p:nvPr/>
        </p:nvSpPr>
        <p:spPr>
          <a:xfrm flipH="1">
            <a:off x="-449902" y="161530"/>
            <a:ext cx="758245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2500" b="1" dirty="0"/>
              <a:t>COVID-19 Precautions in the Otolaryngology </a:t>
            </a:r>
          </a:p>
          <a:p>
            <a:pPr algn="ctr"/>
            <a:r>
              <a:rPr lang="en-CA" sz="2500" b="1" dirty="0"/>
              <a:t>Head and Neck Surgery Clinic 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1614833-AA9A-4A71-B7D4-A8CEFA1B79BB}"/>
              </a:ext>
            </a:extLst>
          </p:cNvPr>
          <p:cNvSpPr txBox="1"/>
          <p:nvPr/>
        </p:nvSpPr>
        <p:spPr>
          <a:xfrm flipH="1">
            <a:off x="450077" y="996641"/>
            <a:ext cx="2930141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3500" b="1" dirty="0"/>
              <a:t>IF YOU HAVE:  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DDF2D35D-8C9B-498E-8F60-11C07903D62F}"/>
              </a:ext>
            </a:extLst>
          </p:cNvPr>
          <p:cNvSpPr/>
          <p:nvPr/>
        </p:nvSpPr>
        <p:spPr>
          <a:xfrm>
            <a:off x="261572" y="1051460"/>
            <a:ext cx="7207719" cy="399353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64" name="Picture 2" descr="Canadian Society of Otolaryngology 73rd Annual Meeting - Edmonton ...">
            <a:extLst>
              <a:ext uri="{FF2B5EF4-FFF2-40B4-BE49-F238E27FC236}">
                <a16:creationId xmlns:a16="http://schemas.microsoft.com/office/drawing/2014/main" id="{A1BF6389-4C25-42C9-AC11-6B3FAFA200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4614" y="9132853"/>
            <a:ext cx="2672748" cy="673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BF1B323F-9395-4386-8A36-B5A0CE716F38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6433626" y="235731"/>
            <a:ext cx="728826" cy="698193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7F13BC31-13F1-4619-863F-B6F60EDD1834}"/>
              </a:ext>
            </a:extLst>
          </p:cNvPr>
          <p:cNvSpPr txBox="1"/>
          <p:nvPr/>
        </p:nvSpPr>
        <p:spPr>
          <a:xfrm flipH="1">
            <a:off x="380316" y="4462764"/>
            <a:ext cx="8129068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500" b="1" dirty="0"/>
              <a:t>PLEASE CALL OUR OFFICE NUMBER: ____________</a:t>
            </a:r>
          </a:p>
        </p:txBody>
      </p:sp>
    </p:spTree>
    <p:extLst>
      <p:ext uri="{BB962C8B-B14F-4D97-AF65-F5344CB8AC3E}">
        <p14:creationId xmlns:p14="http://schemas.microsoft.com/office/powerpoint/2010/main" val="9409879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6D1A73E-4F8B-4E12-B746-B100CBEFD6CB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75455" y="3336909"/>
            <a:ext cx="1012338" cy="116002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C01B4F5-D221-47B7-902C-1C7CF0E14C55}"/>
              </a:ext>
            </a:extLst>
          </p:cNvPr>
          <p:cNvSpPr txBox="1"/>
          <p:nvPr/>
        </p:nvSpPr>
        <p:spPr>
          <a:xfrm>
            <a:off x="2746909" y="3185211"/>
            <a:ext cx="483869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2500" b="1" dirty="0">
                <a:solidFill>
                  <a:srgbClr val="C00000"/>
                </a:solidFill>
              </a:rPr>
              <a:t>Please keep your mask on </a:t>
            </a:r>
            <a:r>
              <a:rPr lang="en-CA" sz="2500" b="1" dirty="0"/>
              <a:t>during the duration of your appointment, removing only when the doctor asks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1BF70B3-25F5-4D11-B42C-FBE143BB90A3}"/>
              </a:ext>
            </a:extLst>
          </p:cNvPr>
          <p:cNvGrpSpPr/>
          <p:nvPr/>
        </p:nvGrpSpPr>
        <p:grpSpPr>
          <a:xfrm>
            <a:off x="1513350" y="3318498"/>
            <a:ext cx="1369296" cy="1276865"/>
            <a:chOff x="9810226" y="3586001"/>
            <a:chExt cx="2895611" cy="2701382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C4863DDE-C306-49D6-AB79-F5E65528C085}"/>
                </a:ext>
              </a:extLst>
            </p:cNvPr>
            <p:cNvGrpSpPr/>
            <p:nvPr/>
          </p:nvGrpSpPr>
          <p:grpSpPr>
            <a:xfrm>
              <a:off x="9810226" y="3586001"/>
              <a:ext cx="2895611" cy="2701382"/>
              <a:chOff x="14437305" y="1724101"/>
              <a:chExt cx="3810000" cy="3810000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155234B5-35F6-4B8C-89E2-BC2D3790B1FF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057019" y="1724101"/>
                <a:ext cx="2570571" cy="2701382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4FD2F853-A969-485A-9BDE-3BE909C9CAD2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437305" y="1724101"/>
                <a:ext cx="3810000" cy="3810000"/>
              </a:xfrm>
              <a:prstGeom prst="rect">
                <a:avLst/>
              </a:prstGeom>
            </p:spPr>
          </p:pic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96D7934E-D5AB-46A7-BCBF-C17F6FC8168B}"/>
                  </a:ext>
                </a:extLst>
              </p:cNvPr>
              <p:cNvGrpSpPr/>
              <p:nvPr/>
            </p:nvGrpSpPr>
            <p:grpSpPr>
              <a:xfrm>
                <a:off x="15770804" y="3030104"/>
                <a:ext cx="1143000" cy="1197993"/>
                <a:chOff x="12649200" y="3564507"/>
                <a:chExt cx="1143000" cy="1197993"/>
              </a:xfrm>
            </p:grpSpPr>
            <p:sp>
              <p:nvSpPr>
                <p:cNvPr id="24" name="Oval 23">
                  <a:extLst>
                    <a:ext uri="{FF2B5EF4-FFF2-40B4-BE49-F238E27FC236}">
                      <a16:creationId xmlns:a16="http://schemas.microsoft.com/office/drawing/2014/main" id="{B871C2AD-CD8E-41EB-AB95-750ABEF3AB10}"/>
                    </a:ext>
                  </a:extLst>
                </p:cNvPr>
                <p:cNvSpPr/>
                <p:nvPr/>
              </p:nvSpPr>
              <p:spPr>
                <a:xfrm>
                  <a:off x="12649200" y="3564507"/>
                  <a:ext cx="1143000" cy="1197993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  <p:cxnSp>
              <p:nvCxnSpPr>
                <p:cNvPr id="25" name="Straight Connector 24">
                  <a:extLst>
                    <a:ext uri="{FF2B5EF4-FFF2-40B4-BE49-F238E27FC236}">
                      <a16:creationId xmlns:a16="http://schemas.microsoft.com/office/drawing/2014/main" id="{084C6A4D-A683-4229-BB85-9F0EACBDE687}"/>
                    </a:ext>
                  </a:extLst>
                </p:cNvPr>
                <p:cNvCxnSpPr/>
                <p:nvPr/>
              </p:nvCxnSpPr>
              <p:spPr>
                <a:xfrm>
                  <a:off x="12954000" y="3894696"/>
                  <a:ext cx="4572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>
                  <a:extLst>
                    <a:ext uri="{FF2B5EF4-FFF2-40B4-BE49-F238E27FC236}">
                      <a16:creationId xmlns:a16="http://schemas.microsoft.com/office/drawing/2014/main" id="{94E68BD1-1E7F-4E17-977F-28B541254704}"/>
                    </a:ext>
                  </a:extLst>
                </p:cNvPr>
                <p:cNvCxnSpPr/>
                <p:nvPr/>
              </p:nvCxnSpPr>
              <p:spPr>
                <a:xfrm>
                  <a:off x="12954000" y="4474206"/>
                  <a:ext cx="4572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F5EFAAC0-3A5B-4033-B57F-AF57C7E758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877800" y="4076700"/>
                  <a:ext cx="6858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78C289B8-45B9-4BD0-B44F-D3E150D7F3C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787312" y="4305300"/>
                  <a:ext cx="852488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0" name="Rectangle: Top Corners Snipped 19">
              <a:extLst>
                <a:ext uri="{FF2B5EF4-FFF2-40B4-BE49-F238E27FC236}">
                  <a16:creationId xmlns:a16="http://schemas.microsoft.com/office/drawing/2014/main" id="{60862EB8-6A53-424A-9FA7-B919DD981A9B}"/>
                </a:ext>
              </a:extLst>
            </p:cNvPr>
            <p:cNvSpPr/>
            <p:nvPr/>
          </p:nvSpPr>
          <p:spPr>
            <a:xfrm>
              <a:off x="10649565" y="3882102"/>
              <a:ext cx="1219200" cy="1515676"/>
            </a:xfrm>
            <a:prstGeom prst="snip2Same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51" name="Rectangle 50">
            <a:extLst>
              <a:ext uri="{FF2B5EF4-FFF2-40B4-BE49-F238E27FC236}">
                <a16:creationId xmlns:a16="http://schemas.microsoft.com/office/drawing/2014/main" id="{C0DFD4BC-2835-4546-A175-887ED87F83A3}"/>
              </a:ext>
            </a:extLst>
          </p:cNvPr>
          <p:cNvSpPr/>
          <p:nvPr/>
        </p:nvSpPr>
        <p:spPr>
          <a:xfrm>
            <a:off x="304800" y="3089500"/>
            <a:ext cx="7188249" cy="179595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DDF2D35D-8C9B-498E-8F60-11C07903D62F}"/>
              </a:ext>
            </a:extLst>
          </p:cNvPr>
          <p:cNvSpPr/>
          <p:nvPr/>
        </p:nvSpPr>
        <p:spPr>
          <a:xfrm>
            <a:off x="304800" y="1255192"/>
            <a:ext cx="7196185" cy="165812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64" name="Picture 2" descr="Canadian Society of Otolaryngology 73rd Annual Meeting - Edmonton ...">
            <a:extLst>
              <a:ext uri="{FF2B5EF4-FFF2-40B4-BE49-F238E27FC236}">
                <a16:creationId xmlns:a16="http://schemas.microsoft.com/office/drawing/2014/main" id="{A1BF6389-4C25-42C9-AC11-6B3FAFA200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8237" y="9142985"/>
            <a:ext cx="2672748" cy="673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7B6C324E-8603-44AA-ADAD-77C19AA478AC}"/>
              </a:ext>
            </a:extLst>
          </p:cNvPr>
          <p:cNvGrpSpPr/>
          <p:nvPr/>
        </p:nvGrpSpPr>
        <p:grpSpPr>
          <a:xfrm>
            <a:off x="296863" y="5029200"/>
            <a:ext cx="7196186" cy="1795952"/>
            <a:chOff x="152083" y="5267925"/>
            <a:chExt cx="7487422" cy="1795952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44507310-647C-4B7E-A4E3-39EDEE8DA8E9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4170" y="5495109"/>
              <a:ext cx="1440794" cy="1341584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488E1A8B-EF7A-49CA-BA03-2D18B06FB241}"/>
                </a:ext>
              </a:extLst>
            </p:cNvPr>
            <p:cNvSpPr/>
            <p:nvPr/>
          </p:nvSpPr>
          <p:spPr>
            <a:xfrm>
              <a:off x="1997464" y="5543431"/>
              <a:ext cx="5468309" cy="12464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CA" sz="2500" b="1" dirty="0"/>
                <a:t>Nasopharyngeal procedures can be irritating </a:t>
              </a:r>
              <a:r>
                <a:rPr lang="en-CA" sz="2500" b="1" dirty="0">
                  <a:solidFill>
                    <a:srgbClr val="C00000"/>
                  </a:solidFill>
                </a:rPr>
                <a:t>please notify your doctor if you are about to sneeze 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FD82CFC2-C622-4512-9AA9-0C11DBD32AB2}"/>
                </a:ext>
              </a:extLst>
            </p:cNvPr>
            <p:cNvSpPr/>
            <p:nvPr/>
          </p:nvSpPr>
          <p:spPr>
            <a:xfrm>
              <a:off x="152083" y="5267925"/>
              <a:ext cx="7487422" cy="1795952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55" name="Rectangle 54">
            <a:extLst>
              <a:ext uri="{FF2B5EF4-FFF2-40B4-BE49-F238E27FC236}">
                <a16:creationId xmlns:a16="http://schemas.microsoft.com/office/drawing/2014/main" id="{4561EEF7-3093-41E2-A0B7-3A68E019F781}"/>
              </a:ext>
            </a:extLst>
          </p:cNvPr>
          <p:cNvSpPr/>
          <p:nvPr/>
        </p:nvSpPr>
        <p:spPr>
          <a:xfrm>
            <a:off x="1726783" y="1282101"/>
            <a:ext cx="4322346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CA" sz="2500" b="1" dirty="0">
                <a:solidFill>
                  <a:srgbClr val="C00000"/>
                </a:solidFill>
              </a:rPr>
              <a:t>WASH YOUR HANDS </a:t>
            </a:r>
            <a:r>
              <a:rPr lang="en-CA" sz="2500" b="1" dirty="0"/>
              <a:t>with hand sanitizer or soap and running water before and after entering the examination room </a:t>
            </a:r>
            <a:endParaRPr lang="en-CA" sz="2500" b="1" dirty="0">
              <a:solidFill>
                <a:srgbClr val="C00000"/>
              </a:solidFill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929D4ED-DF03-44B5-9F5C-69ED54454ECE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38251" y="1392388"/>
            <a:ext cx="1493020" cy="132396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7863453-99BF-46FA-80D6-A8A054C86E6F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6017317" y="1201820"/>
            <a:ext cx="1374896" cy="1742945"/>
          </a:xfrm>
          <a:prstGeom prst="rect">
            <a:avLst/>
          </a:prstGeom>
        </p:spPr>
      </p:pic>
      <p:grpSp>
        <p:nvGrpSpPr>
          <p:cNvPr id="65" name="Group 64">
            <a:extLst>
              <a:ext uri="{FF2B5EF4-FFF2-40B4-BE49-F238E27FC236}">
                <a16:creationId xmlns:a16="http://schemas.microsoft.com/office/drawing/2014/main" id="{5F67497A-B5B8-40E3-AD3F-E3772C9C356F}"/>
              </a:ext>
            </a:extLst>
          </p:cNvPr>
          <p:cNvGrpSpPr/>
          <p:nvPr/>
        </p:nvGrpSpPr>
        <p:grpSpPr>
          <a:xfrm>
            <a:off x="179359" y="6731655"/>
            <a:ext cx="7405699" cy="2341695"/>
            <a:chOff x="-27418" y="4346492"/>
            <a:chExt cx="7647733" cy="2341695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4BB1829E-315F-4486-9B9E-6CEBBE00F5DD}"/>
                </a:ext>
              </a:extLst>
            </p:cNvPr>
            <p:cNvGrpSpPr/>
            <p:nvPr/>
          </p:nvGrpSpPr>
          <p:grpSpPr>
            <a:xfrm>
              <a:off x="-27418" y="4346492"/>
              <a:ext cx="3380218" cy="2286876"/>
              <a:chOff x="327777" y="4395246"/>
              <a:chExt cx="3834860" cy="2618382"/>
            </a:xfrm>
          </p:grpSpPr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53278726-7A8B-405D-B95A-F296D6CF728C}"/>
                  </a:ext>
                </a:extLst>
              </p:cNvPr>
              <p:cNvGrpSpPr/>
              <p:nvPr/>
            </p:nvGrpSpPr>
            <p:grpSpPr>
              <a:xfrm>
                <a:off x="327777" y="4395246"/>
                <a:ext cx="3424713" cy="2261014"/>
                <a:chOff x="862762" y="3951699"/>
                <a:chExt cx="6041361" cy="3810000"/>
              </a:xfrm>
            </p:grpSpPr>
            <p:pic>
              <p:nvPicPr>
                <p:cNvPr id="72" name="Picture 71">
                  <a:extLst>
                    <a:ext uri="{FF2B5EF4-FFF2-40B4-BE49-F238E27FC236}">
                      <a16:creationId xmlns:a16="http://schemas.microsoft.com/office/drawing/2014/main" id="{B5FE58D8-883C-4299-987A-03537B734DF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04207" y="3951699"/>
                  <a:ext cx="3810000" cy="3810000"/>
                </a:xfrm>
                <a:prstGeom prst="rect">
                  <a:avLst/>
                </a:prstGeom>
              </p:spPr>
            </p:pic>
            <p:pic>
              <p:nvPicPr>
                <p:cNvPr id="73" name="Picture 72">
                  <a:extLst>
                    <a:ext uri="{FF2B5EF4-FFF2-40B4-BE49-F238E27FC236}">
                      <a16:creationId xmlns:a16="http://schemas.microsoft.com/office/drawing/2014/main" id="{FBCDE586-E532-4E2D-8E8E-392B7AE1086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862762" y="5310987"/>
                  <a:ext cx="2274831" cy="2179856"/>
                </a:xfrm>
                <a:prstGeom prst="rect">
                  <a:avLst/>
                </a:prstGeom>
              </p:spPr>
            </p:pic>
            <p:pic>
              <p:nvPicPr>
                <p:cNvPr id="74" name="Picture 73">
                  <a:extLst>
                    <a:ext uri="{FF2B5EF4-FFF2-40B4-BE49-F238E27FC236}">
                      <a16:creationId xmlns:a16="http://schemas.microsoft.com/office/drawing/2014/main" id="{B50CFC4A-A6A3-45AC-87F6-90BD0D897B93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9"/>
                <a:srcRect l="36288" t="46000"/>
                <a:stretch/>
              </p:blipFill>
              <p:spPr>
                <a:xfrm>
                  <a:off x="4291761" y="5704299"/>
                  <a:ext cx="2427445" cy="2057400"/>
                </a:xfrm>
                <a:prstGeom prst="rect">
                  <a:avLst/>
                </a:prstGeom>
              </p:spPr>
            </p:pic>
            <p:pic>
              <p:nvPicPr>
                <p:cNvPr id="75" name="Picture 74">
                  <a:extLst>
                    <a:ext uri="{FF2B5EF4-FFF2-40B4-BE49-F238E27FC236}">
                      <a16:creationId xmlns:a16="http://schemas.microsoft.com/office/drawing/2014/main" id="{BA50A84F-D4F6-40DC-BF56-533161C0B67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4629292" y="5310987"/>
                  <a:ext cx="2274831" cy="2179856"/>
                </a:xfrm>
                <a:prstGeom prst="rect">
                  <a:avLst/>
                </a:prstGeom>
              </p:spPr>
            </p:pic>
          </p:grpSp>
          <p:cxnSp>
            <p:nvCxnSpPr>
              <p:cNvPr id="70" name="Straight Arrow Connector 69">
                <a:extLst>
                  <a:ext uri="{FF2B5EF4-FFF2-40B4-BE49-F238E27FC236}">
                    <a16:creationId xmlns:a16="http://schemas.microsoft.com/office/drawing/2014/main" id="{ACA50A7F-0A81-4762-9F3C-CB5D378B82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9934" y="6485232"/>
                <a:ext cx="1655429" cy="0"/>
              </a:xfrm>
              <a:prstGeom prst="straightConnector1">
                <a:avLst/>
              </a:prstGeom>
              <a:ln w="76200">
                <a:solidFill>
                  <a:srgbClr val="FF0000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6E97C05D-D321-424C-B660-DC321EF8DFC4}"/>
                  </a:ext>
                </a:extLst>
              </p:cNvPr>
              <p:cNvSpPr txBox="1"/>
              <p:nvPr/>
            </p:nvSpPr>
            <p:spPr>
              <a:xfrm>
                <a:off x="1735192" y="6459630"/>
                <a:ext cx="2427445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3000" b="1" dirty="0"/>
                  <a:t>2 m </a:t>
                </a:r>
              </a:p>
            </p:txBody>
          </p:sp>
        </p:grp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7DBC005-553D-4C2B-864F-EAAC83F210E6}"/>
                </a:ext>
              </a:extLst>
            </p:cNvPr>
            <p:cNvSpPr txBox="1"/>
            <p:nvPr/>
          </p:nvSpPr>
          <p:spPr>
            <a:xfrm>
              <a:off x="2781616" y="4962520"/>
              <a:ext cx="4838699" cy="1246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500" b="1" dirty="0"/>
                <a:t>Please practice social distancing and try to maintain a distance of 2 meters from those around you 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5334D9E8-CAFB-4E81-A832-2A8C4049CCFD}"/>
                </a:ext>
              </a:extLst>
            </p:cNvPr>
            <p:cNvSpPr/>
            <p:nvPr/>
          </p:nvSpPr>
          <p:spPr>
            <a:xfrm>
              <a:off x="93926" y="4590223"/>
              <a:ext cx="7431373" cy="2097964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76" name="Rectangle 75">
            <a:extLst>
              <a:ext uri="{FF2B5EF4-FFF2-40B4-BE49-F238E27FC236}">
                <a16:creationId xmlns:a16="http://schemas.microsoft.com/office/drawing/2014/main" id="{C8980765-DA25-4212-82B7-9A5CFA485626}"/>
              </a:ext>
            </a:extLst>
          </p:cNvPr>
          <p:cNvSpPr/>
          <p:nvPr/>
        </p:nvSpPr>
        <p:spPr>
          <a:xfrm>
            <a:off x="179359" y="218904"/>
            <a:ext cx="7405699" cy="886055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D340423-AD7B-45FA-9F87-569112F8E871}"/>
              </a:ext>
            </a:extLst>
          </p:cNvPr>
          <p:cNvSpPr txBox="1"/>
          <p:nvPr/>
        </p:nvSpPr>
        <p:spPr>
          <a:xfrm flipH="1">
            <a:off x="-304137" y="208213"/>
            <a:ext cx="723732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2500" b="1" dirty="0"/>
              <a:t>COVID-19 Precautions in the Otolaryngology </a:t>
            </a:r>
          </a:p>
          <a:p>
            <a:pPr algn="ctr"/>
            <a:r>
              <a:rPr lang="en-CA" sz="2500" b="1" dirty="0"/>
              <a:t>Head and Neck Surgery Clinic </a:t>
            </a:r>
          </a:p>
        </p:txBody>
      </p:sp>
      <p:pic>
        <p:nvPicPr>
          <p:cNvPr id="78" name="Picture 77">
            <a:extLst>
              <a:ext uri="{FF2B5EF4-FFF2-40B4-BE49-F238E27FC236}">
                <a16:creationId xmlns:a16="http://schemas.microsoft.com/office/drawing/2014/main" id="{4AEC12EC-BB7C-49E2-8C7D-2AB669F381A1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6660143" y="278667"/>
            <a:ext cx="840842" cy="7640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00978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Oval 91">
            <a:extLst>
              <a:ext uri="{FF2B5EF4-FFF2-40B4-BE49-F238E27FC236}">
                <a16:creationId xmlns:a16="http://schemas.microsoft.com/office/drawing/2014/main" id="{D1EE9BD8-676D-4D6B-B572-41E8523FAC8C}"/>
              </a:ext>
            </a:extLst>
          </p:cNvPr>
          <p:cNvSpPr/>
          <p:nvPr/>
        </p:nvSpPr>
        <p:spPr>
          <a:xfrm>
            <a:off x="4228830" y="7261272"/>
            <a:ext cx="1487265" cy="1335307"/>
          </a:xfrm>
          <a:prstGeom prst="ellipse">
            <a:avLst/>
          </a:prstGeom>
          <a:solidFill>
            <a:schemeClr val="bg1">
              <a:lumMod val="9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b="1"/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EC21EA1F-13E2-47C7-9C77-70FC81552D41}"/>
              </a:ext>
            </a:extLst>
          </p:cNvPr>
          <p:cNvSpPr/>
          <p:nvPr/>
        </p:nvSpPr>
        <p:spPr>
          <a:xfrm>
            <a:off x="4201939" y="3279892"/>
            <a:ext cx="1487265" cy="1335307"/>
          </a:xfrm>
          <a:prstGeom prst="ellipse">
            <a:avLst/>
          </a:prstGeom>
          <a:solidFill>
            <a:schemeClr val="bg1">
              <a:lumMod val="9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b="1"/>
          </a:p>
        </p:txBody>
      </p:sp>
      <p:pic>
        <p:nvPicPr>
          <p:cNvPr id="8" name="Picture 2" descr="Canadian Society of Otolaryngology 73rd Annual Meeting - Edmonton ...">
            <a:extLst>
              <a:ext uri="{FF2B5EF4-FFF2-40B4-BE49-F238E27FC236}">
                <a16:creationId xmlns:a16="http://schemas.microsoft.com/office/drawing/2014/main" id="{817E3767-64AA-496D-93CC-219A5975B8F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5614" y="9173952"/>
            <a:ext cx="2672748" cy="673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E1143B57-F65D-421D-89B8-F5421AD1C9A0}"/>
              </a:ext>
            </a:extLst>
          </p:cNvPr>
          <p:cNvSpPr/>
          <p:nvPr/>
        </p:nvSpPr>
        <p:spPr>
          <a:xfrm>
            <a:off x="264440" y="231323"/>
            <a:ext cx="7274430" cy="94674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b="1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EFBE044-D639-4858-A7CB-C15CEA8D6988}"/>
              </a:ext>
            </a:extLst>
          </p:cNvPr>
          <p:cNvSpPr txBox="1"/>
          <p:nvPr/>
        </p:nvSpPr>
        <p:spPr>
          <a:xfrm flipH="1">
            <a:off x="-510878" y="313706"/>
            <a:ext cx="758245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2500" b="1" dirty="0"/>
              <a:t>COVID-19 Precautions in the OHNS-Clinic </a:t>
            </a:r>
          </a:p>
          <a:p>
            <a:pPr algn="ctr"/>
            <a:r>
              <a:rPr lang="en-CA" sz="2500" b="1" dirty="0"/>
              <a:t>for the Clinician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15F0D907-CA4A-4BB8-A0FB-2A7B906518B5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227424" y="317476"/>
            <a:ext cx="880940" cy="764062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341201EE-E5CF-4F0B-9939-B2112BC3AC68}"/>
              </a:ext>
            </a:extLst>
          </p:cNvPr>
          <p:cNvSpPr/>
          <p:nvPr/>
        </p:nvSpPr>
        <p:spPr>
          <a:xfrm>
            <a:off x="1786612" y="5409881"/>
            <a:ext cx="2230220" cy="10395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Clean and disinfect</a:t>
            </a:r>
          </a:p>
          <a:p>
            <a:r>
              <a:rPr lang="en-US" sz="2000" b="1" dirty="0"/>
              <a:t> frequently touched surfaces</a:t>
            </a:r>
            <a:endParaRPr lang="en-CA" sz="2000" b="1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BF73F18-B38E-409A-89D0-8C580FA58536}"/>
              </a:ext>
            </a:extLst>
          </p:cNvPr>
          <p:cNvSpPr/>
          <p:nvPr/>
        </p:nvSpPr>
        <p:spPr>
          <a:xfrm>
            <a:off x="1845971" y="3497619"/>
            <a:ext cx="217125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Hand sanitizers should be readily available</a:t>
            </a:r>
            <a:endParaRPr lang="en-CA" sz="2000" b="1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FE5DA0F-BAE1-4A07-A10B-AF9C8EFFCEC6}"/>
              </a:ext>
            </a:extLst>
          </p:cNvPr>
          <p:cNvSpPr/>
          <p:nvPr/>
        </p:nvSpPr>
        <p:spPr>
          <a:xfrm>
            <a:off x="1919630" y="7329675"/>
            <a:ext cx="1880871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2000" b="1" dirty="0"/>
              <a:t>Declutter space: remove hand outs, models, etc.</a:t>
            </a: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3943BA5B-FFFF-4AA9-9175-EEBE4B624FA8}"/>
              </a:ext>
            </a:extLst>
          </p:cNvPr>
          <p:cNvGrpSpPr/>
          <p:nvPr/>
        </p:nvGrpSpPr>
        <p:grpSpPr>
          <a:xfrm>
            <a:off x="4277250" y="3501324"/>
            <a:ext cx="1351375" cy="838176"/>
            <a:chOff x="228178" y="1762115"/>
            <a:chExt cx="1922319" cy="1219200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4D22A344-055F-4DAC-8A4E-C795659FE15E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8178" y="1762115"/>
              <a:ext cx="1922319" cy="1219200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F59FE06A-0479-414D-A98E-3002E55D93B2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10999" y="2115801"/>
              <a:ext cx="665816" cy="733654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CA6A2572-9543-4080-BB7B-C62B95820C3A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57265" y="2118911"/>
              <a:ext cx="613299" cy="611772"/>
            </a:xfrm>
            <a:prstGeom prst="rect">
              <a:avLst/>
            </a:prstGeom>
          </p:spPr>
        </p:pic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AA15A26C-E890-4698-87F8-2621391E327C}"/>
              </a:ext>
            </a:extLst>
          </p:cNvPr>
          <p:cNvGrpSpPr/>
          <p:nvPr/>
        </p:nvGrpSpPr>
        <p:grpSpPr>
          <a:xfrm>
            <a:off x="284038" y="3518992"/>
            <a:ext cx="1408942" cy="801464"/>
            <a:chOff x="100347" y="2792069"/>
            <a:chExt cx="1451137" cy="807803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CF3FCF7F-82D1-48E2-B87F-69D9B9A3357A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 flipH="1">
              <a:off x="100347" y="2792069"/>
              <a:ext cx="821304" cy="807803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17E828F0-A7AE-4D0A-8E28-14C001BF6186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25855" y="2960905"/>
              <a:ext cx="925629" cy="627807"/>
            </a:xfrm>
            <a:prstGeom prst="rect">
              <a:avLst/>
            </a:prstGeom>
          </p:spPr>
        </p:pic>
      </p:grpSp>
      <p:pic>
        <p:nvPicPr>
          <p:cNvPr id="46" name="Picture 45">
            <a:extLst>
              <a:ext uri="{FF2B5EF4-FFF2-40B4-BE49-F238E27FC236}">
                <a16:creationId xmlns:a16="http://schemas.microsoft.com/office/drawing/2014/main" id="{A97410EF-EF37-4804-9AE7-511CB53799FA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75827" y="5291410"/>
            <a:ext cx="983833" cy="1219201"/>
          </a:xfrm>
          <a:prstGeom prst="rect">
            <a:avLst/>
          </a:prstGeom>
        </p:spPr>
      </p:pic>
      <p:grpSp>
        <p:nvGrpSpPr>
          <p:cNvPr id="69" name="Group 68">
            <a:extLst>
              <a:ext uri="{FF2B5EF4-FFF2-40B4-BE49-F238E27FC236}">
                <a16:creationId xmlns:a16="http://schemas.microsoft.com/office/drawing/2014/main" id="{9C8B110F-8440-4C39-918B-04269EF2C268}"/>
              </a:ext>
            </a:extLst>
          </p:cNvPr>
          <p:cNvGrpSpPr/>
          <p:nvPr/>
        </p:nvGrpSpPr>
        <p:grpSpPr>
          <a:xfrm>
            <a:off x="257895" y="7387768"/>
            <a:ext cx="1074260" cy="1181048"/>
            <a:chOff x="6181341" y="5489409"/>
            <a:chExt cx="1430902" cy="1380189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FEB5D86D-4C94-4E53-A6B7-4FAB9CBDAA51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181341" y="5650397"/>
              <a:ext cx="900519" cy="1219201"/>
            </a:xfrm>
            <a:prstGeom prst="rect">
              <a:avLst/>
            </a:prstGeom>
          </p:spPr>
        </p:pic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94295CF9-877B-41D3-B13A-C43054AD2D2D}"/>
                </a:ext>
              </a:extLst>
            </p:cNvPr>
            <p:cNvGrpSpPr/>
            <p:nvPr/>
          </p:nvGrpSpPr>
          <p:grpSpPr>
            <a:xfrm>
              <a:off x="7123900" y="5489409"/>
              <a:ext cx="488343" cy="1285875"/>
              <a:chOff x="3637976" y="6093085"/>
              <a:chExt cx="913243" cy="1974590"/>
            </a:xfrm>
          </p:grpSpPr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2DD96B83-2A35-4D2F-9A35-318A1A752677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655869" y="6093085"/>
                <a:ext cx="895350" cy="781050"/>
              </a:xfrm>
              <a:prstGeom prst="rect">
                <a:avLst/>
              </a:prstGeom>
            </p:spPr>
          </p:pic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2C466C4D-B0B3-40CC-8B9C-244576A5FD1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3637976" y="6753225"/>
                <a:ext cx="895350" cy="1314450"/>
              </a:xfrm>
              <a:prstGeom prst="rect">
                <a:avLst/>
              </a:prstGeom>
            </p:spPr>
          </p:pic>
        </p:grp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C8198085-071A-469B-9729-7B5A2CF0781D}"/>
              </a:ext>
            </a:extLst>
          </p:cNvPr>
          <p:cNvGrpSpPr/>
          <p:nvPr/>
        </p:nvGrpSpPr>
        <p:grpSpPr>
          <a:xfrm>
            <a:off x="4343325" y="7418569"/>
            <a:ext cx="1180761" cy="948024"/>
            <a:chOff x="2983373" y="6249868"/>
            <a:chExt cx="1922319" cy="1219200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C019037C-CDA7-4F5E-8378-BC8D3A54E4CF}"/>
                </a:ext>
              </a:extLst>
            </p:cNvPr>
            <p:cNvPicPr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 rot="5400000">
              <a:off x="3671053" y="6497479"/>
              <a:ext cx="666750" cy="857250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1D1DAA0E-EE0D-4C08-A692-C3608A493B40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83373" y="6249868"/>
              <a:ext cx="1922319" cy="1219200"/>
            </a:xfrm>
            <a:prstGeom prst="rect">
              <a:avLst/>
            </a:prstGeom>
          </p:spPr>
        </p:pic>
      </p:grpSp>
      <p:sp>
        <p:nvSpPr>
          <p:cNvPr id="91" name="Oval 90">
            <a:extLst>
              <a:ext uri="{FF2B5EF4-FFF2-40B4-BE49-F238E27FC236}">
                <a16:creationId xmlns:a16="http://schemas.microsoft.com/office/drawing/2014/main" id="{E7E59BF9-97EA-4C7C-BC3B-9694646A9331}"/>
              </a:ext>
            </a:extLst>
          </p:cNvPr>
          <p:cNvSpPr/>
          <p:nvPr/>
        </p:nvSpPr>
        <p:spPr>
          <a:xfrm>
            <a:off x="4225842" y="5309624"/>
            <a:ext cx="1487265" cy="1335307"/>
          </a:xfrm>
          <a:prstGeom prst="ellipse">
            <a:avLst/>
          </a:prstGeom>
          <a:solidFill>
            <a:schemeClr val="bg1">
              <a:lumMod val="9500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b="1"/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85731017-C3F6-4DB6-B168-58203D693708}"/>
              </a:ext>
            </a:extLst>
          </p:cNvPr>
          <p:cNvGrpSpPr/>
          <p:nvPr/>
        </p:nvGrpSpPr>
        <p:grpSpPr>
          <a:xfrm>
            <a:off x="4211969" y="5303653"/>
            <a:ext cx="1481938" cy="1335324"/>
            <a:chOff x="6625992" y="3913484"/>
            <a:chExt cx="3810000" cy="3810000"/>
          </a:xfrm>
        </p:grpSpPr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C4BA57C2-F533-4C92-95A7-C6776D0CD0AB}"/>
                </a:ext>
              </a:extLst>
            </p:cNvPr>
            <p:cNvPicPr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436739" y="4648199"/>
              <a:ext cx="2562650" cy="2340571"/>
            </a:xfrm>
            <a:prstGeom prst="rect">
              <a:avLst/>
            </a:prstGeom>
          </p:spPr>
        </p:pic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25B8CFA8-30EF-41F4-BD2D-919536D0CC82}"/>
                </a:ext>
              </a:extLst>
            </p:cNvPr>
            <p:cNvPicPr>
              <a:picLocks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6625992" y="3913484"/>
              <a:ext cx="3810000" cy="3810000"/>
            </a:xfrm>
            <a:prstGeom prst="rect">
              <a:avLst/>
            </a:prstGeom>
          </p:spPr>
        </p:pic>
      </p:grpSp>
      <p:sp>
        <p:nvSpPr>
          <p:cNvPr id="51" name="Rectangle 50">
            <a:extLst>
              <a:ext uri="{FF2B5EF4-FFF2-40B4-BE49-F238E27FC236}">
                <a16:creationId xmlns:a16="http://schemas.microsoft.com/office/drawing/2014/main" id="{C10B8964-7813-4F98-AE88-E48D29D100E5}"/>
              </a:ext>
            </a:extLst>
          </p:cNvPr>
          <p:cNvSpPr/>
          <p:nvPr/>
        </p:nvSpPr>
        <p:spPr>
          <a:xfrm>
            <a:off x="264439" y="3234505"/>
            <a:ext cx="7274431" cy="2035825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b="1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97143C73-22BB-461F-9A8F-1A861A8B61B6}"/>
              </a:ext>
            </a:extLst>
          </p:cNvPr>
          <p:cNvSpPr/>
          <p:nvPr/>
        </p:nvSpPr>
        <p:spPr>
          <a:xfrm>
            <a:off x="257893" y="5254560"/>
            <a:ext cx="7274431" cy="203582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b="1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064B58A6-C77D-442D-B7C7-8A9447E32855}"/>
              </a:ext>
            </a:extLst>
          </p:cNvPr>
          <p:cNvSpPr/>
          <p:nvPr/>
        </p:nvSpPr>
        <p:spPr>
          <a:xfrm>
            <a:off x="257893" y="7287358"/>
            <a:ext cx="7300575" cy="187137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b="1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63F6E5B6-FD09-4E13-976E-5F2F3081A4B4}"/>
              </a:ext>
            </a:extLst>
          </p:cNvPr>
          <p:cNvSpPr/>
          <p:nvPr/>
        </p:nvSpPr>
        <p:spPr>
          <a:xfrm>
            <a:off x="1932881" y="5555769"/>
            <a:ext cx="204703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Clean &amp; disinfect</a:t>
            </a:r>
          </a:p>
          <a:p>
            <a:r>
              <a:rPr lang="en-US" sz="2000" b="1" dirty="0"/>
              <a:t> frequently touched surfaces</a:t>
            </a:r>
            <a:endParaRPr lang="en-CA" sz="2000" b="1" dirty="0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191CAA9D-31CB-4DC0-A46F-036949807620}"/>
              </a:ext>
            </a:extLst>
          </p:cNvPr>
          <p:cNvSpPr/>
          <p:nvPr/>
        </p:nvSpPr>
        <p:spPr>
          <a:xfrm>
            <a:off x="5534940" y="5456343"/>
            <a:ext cx="2093189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Eliminate clipboards and pens in patient care areas</a:t>
            </a:r>
            <a:endParaRPr lang="en-CA" sz="2000" b="1" dirty="0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BE3255D0-21F5-49DF-A958-829052EA3C8A}"/>
              </a:ext>
            </a:extLst>
          </p:cNvPr>
          <p:cNvSpPr/>
          <p:nvPr/>
        </p:nvSpPr>
        <p:spPr>
          <a:xfrm>
            <a:off x="1872440" y="3651924"/>
            <a:ext cx="217125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Hand sanitizers should be readily available</a:t>
            </a:r>
            <a:endParaRPr lang="en-CA" sz="2000" b="1" dirty="0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FF6B168E-8DFB-4290-B4B5-75557BCD77A8}"/>
              </a:ext>
            </a:extLst>
          </p:cNvPr>
          <p:cNvSpPr/>
          <p:nvPr/>
        </p:nvSpPr>
        <p:spPr>
          <a:xfrm>
            <a:off x="5443360" y="3676238"/>
            <a:ext cx="204500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anitize/Cover “used reusable PPE” container</a:t>
            </a:r>
            <a:endParaRPr lang="en-CA" sz="2000" b="1" dirty="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E73EACD8-EEA7-456C-80A2-B18D4F1DEFE6}"/>
              </a:ext>
            </a:extLst>
          </p:cNvPr>
          <p:cNvSpPr/>
          <p:nvPr/>
        </p:nvSpPr>
        <p:spPr>
          <a:xfrm>
            <a:off x="2048756" y="7478685"/>
            <a:ext cx="1880871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2000" b="1" dirty="0"/>
              <a:t>Declutter space: remove hand outs, models, etc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184FD57-F5A4-4B2F-8BF4-FD068DF26E93}"/>
              </a:ext>
            </a:extLst>
          </p:cNvPr>
          <p:cNvGrpSpPr/>
          <p:nvPr/>
        </p:nvGrpSpPr>
        <p:grpSpPr>
          <a:xfrm>
            <a:off x="3947798" y="3523948"/>
            <a:ext cx="1487265" cy="1335307"/>
            <a:chOff x="3945010" y="3252129"/>
            <a:chExt cx="1487265" cy="1335307"/>
          </a:xfrm>
        </p:grpSpPr>
        <p:sp>
          <p:nvSpPr>
            <p:cNvPr id="62" name="Oval 61">
              <a:extLst>
                <a:ext uri="{FF2B5EF4-FFF2-40B4-BE49-F238E27FC236}">
                  <a16:creationId xmlns:a16="http://schemas.microsoft.com/office/drawing/2014/main" id="{06B19018-E51F-4568-B938-3B10D0598457}"/>
                </a:ext>
              </a:extLst>
            </p:cNvPr>
            <p:cNvSpPr/>
            <p:nvPr/>
          </p:nvSpPr>
          <p:spPr>
            <a:xfrm>
              <a:off x="3945010" y="3252129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ECC4140B-A616-4CE1-A366-F872EB9D406F}"/>
                </a:ext>
              </a:extLst>
            </p:cNvPr>
            <p:cNvGrpSpPr/>
            <p:nvPr/>
          </p:nvGrpSpPr>
          <p:grpSpPr>
            <a:xfrm>
              <a:off x="4020321" y="3473561"/>
              <a:ext cx="1351375" cy="838176"/>
              <a:chOff x="228178" y="1762115"/>
              <a:chExt cx="1922319" cy="1219200"/>
            </a:xfrm>
          </p:grpSpPr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id="{A149CEA2-E558-40F1-B6F9-222EA7091A32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28178" y="1762115"/>
                <a:ext cx="1922319" cy="1219200"/>
              </a:xfrm>
              <a:prstGeom prst="rect">
                <a:avLst/>
              </a:prstGeom>
            </p:spPr>
          </p:pic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id="{91F2C6AA-94DE-45B3-B19C-4737105BBD6E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10999" y="2115801"/>
                <a:ext cx="665816" cy="733654"/>
              </a:xfrm>
              <a:prstGeom prst="rect">
                <a:avLst/>
              </a:prstGeom>
            </p:spPr>
          </p:pic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id="{ED17F876-BC7B-43CE-937E-A62E48A57D14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257265" y="2118911"/>
                <a:ext cx="613299" cy="611772"/>
              </a:xfrm>
              <a:prstGeom prst="rect">
                <a:avLst/>
              </a:prstGeom>
            </p:spPr>
          </p:pic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C95843CC-A4ED-48C4-BACF-5C3BC47AB25A}"/>
              </a:ext>
            </a:extLst>
          </p:cNvPr>
          <p:cNvGrpSpPr/>
          <p:nvPr/>
        </p:nvGrpSpPr>
        <p:grpSpPr>
          <a:xfrm>
            <a:off x="375508" y="3539403"/>
            <a:ext cx="1518991" cy="1335307"/>
            <a:chOff x="173989" y="3337798"/>
            <a:chExt cx="1518991" cy="1335307"/>
          </a:xfrm>
        </p:grpSpPr>
        <p:sp>
          <p:nvSpPr>
            <p:cNvPr id="63" name="Oval 62">
              <a:extLst>
                <a:ext uri="{FF2B5EF4-FFF2-40B4-BE49-F238E27FC236}">
                  <a16:creationId xmlns:a16="http://schemas.microsoft.com/office/drawing/2014/main" id="{671D7E86-DB71-409C-8F28-7A8B851963DE}"/>
                </a:ext>
              </a:extLst>
            </p:cNvPr>
            <p:cNvSpPr/>
            <p:nvPr/>
          </p:nvSpPr>
          <p:spPr>
            <a:xfrm>
              <a:off x="173989" y="3337798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0095B5CD-72B6-4835-A84E-EA4979DD096A}"/>
                </a:ext>
              </a:extLst>
            </p:cNvPr>
            <p:cNvGrpSpPr/>
            <p:nvPr/>
          </p:nvGrpSpPr>
          <p:grpSpPr>
            <a:xfrm>
              <a:off x="284038" y="3518992"/>
              <a:ext cx="1408942" cy="801464"/>
              <a:chOff x="100347" y="2792069"/>
              <a:chExt cx="1451137" cy="807803"/>
            </a:xfrm>
          </p:grpSpPr>
          <p:pic>
            <p:nvPicPr>
              <p:cNvPr id="85" name="Picture 84">
                <a:extLst>
                  <a:ext uri="{FF2B5EF4-FFF2-40B4-BE49-F238E27FC236}">
                    <a16:creationId xmlns:a16="http://schemas.microsoft.com/office/drawing/2014/main" id="{E8116AA5-D77F-424F-AA16-0381561DFA5A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 flipH="1">
                <a:off x="100347" y="2792069"/>
                <a:ext cx="821304" cy="807803"/>
              </a:xfrm>
              <a:prstGeom prst="rect">
                <a:avLst/>
              </a:prstGeom>
            </p:spPr>
          </p:pic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46E9A173-C96B-4549-A56B-6E2151916704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25855" y="2960905"/>
                <a:ext cx="925629" cy="627807"/>
              </a:xfrm>
              <a:prstGeom prst="rect">
                <a:avLst/>
              </a:prstGeom>
            </p:spPr>
          </p:pic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3A4346EA-EC01-41BC-B88B-F0BA04B78E92}"/>
              </a:ext>
            </a:extLst>
          </p:cNvPr>
          <p:cNvGrpSpPr/>
          <p:nvPr/>
        </p:nvGrpSpPr>
        <p:grpSpPr>
          <a:xfrm>
            <a:off x="410832" y="5514879"/>
            <a:ext cx="1487265" cy="1353521"/>
            <a:chOff x="158991" y="5291410"/>
            <a:chExt cx="1487265" cy="1353521"/>
          </a:xfrm>
        </p:grpSpPr>
        <p:sp>
          <p:nvSpPr>
            <p:cNvPr id="59" name="Oval 58">
              <a:extLst>
                <a:ext uri="{FF2B5EF4-FFF2-40B4-BE49-F238E27FC236}">
                  <a16:creationId xmlns:a16="http://schemas.microsoft.com/office/drawing/2014/main" id="{DE4E21AB-BF0E-4B47-9324-7006B3F10809}"/>
                </a:ext>
              </a:extLst>
            </p:cNvPr>
            <p:cNvSpPr/>
            <p:nvPr/>
          </p:nvSpPr>
          <p:spPr>
            <a:xfrm>
              <a:off x="158991" y="5309624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E0D181D4-F24E-441B-846E-D8C6AB7336FA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5827" y="5291410"/>
              <a:ext cx="983833" cy="1219201"/>
            </a:xfrm>
            <a:prstGeom prst="rect">
              <a:avLst/>
            </a:prstGeom>
          </p:spPr>
        </p:pic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CAACD9C7-A3A7-4A9F-B301-79CAFD9BFEA3}"/>
              </a:ext>
            </a:extLst>
          </p:cNvPr>
          <p:cNvGrpSpPr/>
          <p:nvPr/>
        </p:nvGrpSpPr>
        <p:grpSpPr>
          <a:xfrm>
            <a:off x="436642" y="7571995"/>
            <a:ext cx="1487265" cy="1335307"/>
            <a:chOff x="188259" y="7329675"/>
            <a:chExt cx="1487265" cy="1335307"/>
          </a:xfrm>
        </p:grpSpPr>
        <p:sp>
          <p:nvSpPr>
            <p:cNvPr id="60" name="Oval 59">
              <a:extLst>
                <a:ext uri="{FF2B5EF4-FFF2-40B4-BE49-F238E27FC236}">
                  <a16:creationId xmlns:a16="http://schemas.microsoft.com/office/drawing/2014/main" id="{7DAB3987-0406-4E7E-BC5C-74F0710997A5}"/>
                </a:ext>
              </a:extLst>
            </p:cNvPr>
            <p:cNvSpPr/>
            <p:nvPr/>
          </p:nvSpPr>
          <p:spPr>
            <a:xfrm>
              <a:off x="188259" y="7329675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D739B6A0-746E-4118-B3AC-147577925CE8}"/>
                </a:ext>
              </a:extLst>
            </p:cNvPr>
            <p:cNvGrpSpPr/>
            <p:nvPr/>
          </p:nvGrpSpPr>
          <p:grpSpPr>
            <a:xfrm>
              <a:off x="257895" y="7387768"/>
              <a:ext cx="1074260" cy="1181048"/>
              <a:chOff x="6181341" y="5489409"/>
              <a:chExt cx="1430902" cy="1380189"/>
            </a:xfrm>
          </p:grpSpPr>
          <p:pic>
            <p:nvPicPr>
              <p:cNvPr id="98" name="Picture 97">
                <a:extLst>
                  <a:ext uri="{FF2B5EF4-FFF2-40B4-BE49-F238E27FC236}">
                    <a16:creationId xmlns:a16="http://schemas.microsoft.com/office/drawing/2014/main" id="{1DA48E28-8ED2-4497-8B3F-9CA401336305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6181341" y="5650397"/>
                <a:ext cx="900519" cy="1219201"/>
              </a:xfrm>
              <a:prstGeom prst="rect">
                <a:avLst/>
              </a:prstGeom>
            </p:spPr>
          </p:pic>
          <p:grpSp>
            <p:nvGrpSpPr>
              <p:cNvPr id="99" name="Group 98">
                <a:extLst>
                  <a:ext uri="{FF2B5EF4-FFF2-40B4-BE49-F238E27FC236}">
                    <a16:creationId xmlns:a16="http://schemas.microsoft.com/office/drawing/2014/main" id="{005A5167-D74D-43FC-8C5E-631E2EE48442}"/>
                  </a:ext>
                </a:extLst>
              </p:cNvPr>
              <p:cNvGrpSpPr/>
              <p:nvPr/>
            </p:nvGrpSpPr>
            <p:grpSpPr>
              <a:xfrm>
                <a:off x="7123900" y="5489409"/>
                <a:ext cx="488343" cy="1285875"/>
                <a:chOff x="3637976" y="6093085"/>
                <a:chExt cx="913243" cy="1974590"/>
              </a:xfrm>
            </p:grpSpPr>
            <p:pic>
              <p:nvPicPr>
                <p:cNvPr id="100" name="Picture 99">
                  <a:extLst>
                    <a:ext uri="{FF2B5EF4-FFF2-40B4-BE49-F238E27FC236}">
                      <a16:creationId xmlns:a16="http://schemas.microsoft.com/office/drawing/2014/main" id="{0DAE21F9-BCFC-4DBE-ABBB-29E2F5378EF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3655869" y="6093085"/>
                  <a:ext cx="895350" cy="781050"/>
                </a:xfrm>
                <a:prstGeom prst="rect">
                  <a:avLst/>
                </a:prstGeom>
              </p:spPr>
            </p:pic>
            <p:pic>
              <p:nvPicPr>
                <p:cNvPr id="101" name="Picture 100">
                  <a:extLst>
                    <a:ext uri="{FF2B5EF4-FFF2-40B4-BE49-F238E27FC236}">
                      <a16:creationId xmlns:a16="http://schemas.microsoft.com/office/drawing/2014/main" id="{69A64676-6892-4111-9B8E-568A581A9FC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3637976" y="6753225"/>
                  <a:ext cx="895350" cy="1314450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102" name="Rectangle 101">
            <a:extLst>
              <a:ext uri="{FF2B5EF4-FFF2-40B4-BE49-F238E27FC236}">
                <a16:creationId xmlns:a16="http://schemas.microsoft.com/office/drawing/2014/main" id="{891A47C9-7795-426D-9256-5224AFBD171D}"/>
              </a:ext>
            </a:extLst>
          </p:cNvPr>
          <p:cNvSpPr/>
          <p:nvPr/>
        </p:nvSpPr>
        <p:spPr>
          <a:xfrm>
            <a:off x="5414531" y="7541901"/>
            <a:ext cx="247018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2000" b="1" dirty="0"/>
              <a:t>Covered bins for transporting dirty instruments and scope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9CB994F-5E7D-45BA-AEF9-B022DA1AA65A}"/>
              </a:ext>
            </a:extLst>
          </p:cNvPr>
          <p:cNvGrpSpPr/>
          <p:nvPr/>
        </p:nvGrpSpPr>
        <p:grpSpPr>
          <a:xfrm>
            <a:off x="3899101" y="7624573"/>
            <a:ext cx="1487265" cy="1335307"/>
            <a:chOff x="3971901" y="7233509"/>
            <a:chExt cx="1487265" cy="1335307"/>
          </a:xfrm>
        </p:grpSpPr>
        <p:sp>
          <p:nvSpPr>
            <p:cNvPr id="61" name="Oval 60">
              <a:extLst>
                <a:ext uri="{FF2B5EF4-FFF2-40B4-BE49-F238E27FC236}">
                  <a16:creationId xmlns:a16="http://schemas.microsoft.com/office/drawing/2014/main" id="{554B233E-0FF4-4E06-A1A2-72952594C879}"/>
                </a:ext>
              </a:extLst>
            </p:cNvPr>
            <p:cNvSpPr/>
            <p:nvPr/>
          </p:nvSpPr>
          <p:spPr>
            <a:xfrm>
              <a:off x="3971901" y="7233509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768F09EC-A543-4AEC-8144-D70E5E3EAEB8}"/>
                </a:ext>
              </a:extLst>
            </p:cNvPr>
            <p:cNvGrpSpPr/>
            <p:nvPr/>
          </p:nvGrpSpPr>
          <p:grpSpPr>
            <a:xfrm>
              <a:off x="4086396" y="7390806"/>
              <a:ext cx="1180761" cy="948024"/>
              <a:chOff x="2983373" y="6249868"/>
              <a:chExt cx="1922319" cy="1219200"/>
            </a:xfrm>
          </p:grpSpPr>
          <p:pic>
            <p:nvPicPr>
              <p:cNvPr id="104" name="Picture 103">
                <a:extLst>
                  <a:ext uri="{FF2B5EF4-FFF2-40B4-BE49-F238E27FC236}">
                    <a16:creationId xmlns:a16="http://schemas.microsoft.com/office/drawing/2014/main" id="{4DF17C04-EBB6-45D1-94EC-1BEEC48A1868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 rot="5400000">
                <a:off x="3671053" y="6497479"/>
                <a:ext cx="666750" cy="857250"/>
              </a:xfrm>
              <a:prstGeom prst="rect">
                <a:avLst/>
              </a:prstGeom>
            </p:spPr>
          </p:pic>
          <p:pic>
            <p:nvPicPr>
              <p:cNvPr id="105" name="Picture 104">
                <a:extLst>
                  <a:ext uri="{FF2B5EF4-FFF2-40B4-BE49-F238E27FC236}">
                    <a16:creationId xmlns:a16="http://schemas.microsoft.com/office/drawing/2014/main" id="{F2CDF258-B1A6-4C10-9134-294BC4749E59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983373" y="6249868"/>
                <a:ext cx="1922319" cy="1219200"/>
              </a:xfrm>
              <a:prstGeom prst="rect">
                <a:avLst/>
              </a:prstGeom>
            </p:spPr>
          </p:pic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1B4998A3-9680-43B6-9C0B-E89B0166974D}"/>
              </a:ext>
            </a:extLst>
          </p:cNvPr>
          <p:cNvGrpSpPr/>
          <p:nvPr/>
        </p:nvGrpSpPr>
        <p:grpSpPr>
          <a:xfrm>
            <a:off x="257894" y="1236682"/>
            <a:ext cx="7280976" cy="1971249"/>
            <a:chOff x="13535" y="1217477"/>
            <a:chExt cx="7782716" cy="2060429"/>
          </a:xfrm>
        </p:grpSpPr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8363766C-C412-4CCA-A96B-462BD6401315}"/>
                </a:ext>
              </a:extLst>
            </p:cNvPr>
            <p:cNvSpPr/>
            <p:nvPr/>
          </p:nvSpPr>
          <p:spPr>
            <a:xfrm>
              <a:off x="131794" y="1635316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990199B-2ECA-4A8A-AC35-472346979275}"/>
                </a:ext>
              </a:extLst>
            </p:cNvPr>
            <p:cNvSpPr/>
            <p:nvPr/>
          </p:nvSpPr>
          <p:spPr>
            <a:xfrm>
              <a:off x="1646256" y="1712622"/>
              <a:ext cx="2819424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000" b="1" dirty="0"/>
                <a:t>Keep all doors open to minimize contact with door handles</a:t>
              </a:r>
              <a:endParaRPr lang="en-CA" sz="2000" b="1" dirty="0"/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9C262744-5553-4D61-A10B-E5988431DE9E}"/>
                </a:ext>
              </a:extLst>
            </p:cNvPr>
            <p:cNvPicPr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79482" y="1797989"/>
              <a:ext cx="937152" cy="989003"/>
            </a:xfrm>
            <a:prstGeom prst="rect">
              <a:avLst/>
            </a:prstGeom>
          </p:spPr>
        </p:pic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F24696C6-6460-4C92-8672-062D0C5D69EE}"/>
                </a:ext>
              </a:extLst>
            </p:cNvPr>
            <p:cNvSpPr/>
            <p:nvPr/>
          </p:nvSpPr>
          <p:spPr>
            <a:xfrm>
              <a:off x="5643295" y="1719542"/>
              <a:ext cx="2145959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000" b="1" dirty="0"/>
                <a:t>No touch trash bins with disposable linings</a:t>
              </a:r>
              <a:endParaRPr lang="en-CA" sz="2000" b="1" dirty="0"/>
            </a:p>
          </p:txBody>
        </p: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F37B9D59-9E3F-4C72-84F0-FAE005C835AB}"/>
                </a:ext>
              </a:extLst>
            </p:cNvPr>
            <p:cNvGrpSpPr/>
            <p:nvPr/>
          </p:nvGrpSpPr>
          <p:grpSpPr>
            <a:xfrm>
              <a:off x="4126989" y="1655142"/>
              <a:ext cx="1487265" cy="1335307"/>
              <a:chOff x="4257602" y="2132769"/>
              <a:chExt cx="1487265" cy="1335307"/>
            </a:xfrm>
          </p:grpSpPr>
          <p:sp>
            <p:nvSpPr>
              <p:cNvPr id="82" name="Oval 81">
                <a:extLst>
                  <a:ext uri="{FF2B5EF4-FFF2-40B4-BE49-F238E27FC236}">
                    <a16:creationId xmlns:a16="http://schemas.microsoft.com/office/drawing/2014/main" id="{E52D2A65-ED27-42AD-9540-CA9B0E54C69B}"/>
                  </a:ext>
                </a:extLst>
              </p:cNvPr>
              <p:cNvSpPr/>
              <p:nvPr/>
            </p:nvSpPr>
            <p:spPr>
              <a:xfrm>
                <a:off x="4257602" y="2132769"/>
                <a:ext cx="1487265" cy="1335307"/>
              </a:xfrm>
              <a:prstGeom prst="ellipse">
                <a:avLst/>
              </a:prstGeom>
              <a:solidFill>
                <a:schemeClr val="bg1">
                  <a:lumMod val="95000"/>
                </a:schemeClr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b="1" dirty="0"/>
              </a:p>
            </p:txBody>
          </p:sp>
          <p:pic>
            <p:nvPicPr>
              <p:cNvPr id="83" name="Picture 82">
                <a:extLst>
                  <a:ext uri="{FF2B5EF4-FFF2-40B4-BE49-F238E27FC236}">
                    <a16:creationId xmlns:a16="http://schemas.microsoft.com/office/drawing/2014/main" id="{F0FA9A88-5D04-4C46-91D5-1534FC930E0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4557673" y="2392632"/>
                <a:ext cx="887447" cy="837229"/>
              </a:xfrm>
              <a:prstGeom prst="rect">
                <a:avLst/>
              </a:prstGeom>
            </p:spPr>
          </p:pic>
        </p:grp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0AA6861A-1FCF-4825-8B93-F3E67E06257F}"/>
                </a:ext>
              </a:extLst>
            </p:cNvPr>
            <p:cNvSpPr/>
            <p:nvPr/>
          </p:nvSpPr>
          <p:spPr>
            <a:xfrm>
              <a:off x="13535" y="1217477"/>
              <a:ext cx="7782716" cy="2060429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50B0029E-89E8-4B11-92D2-AA11A7FD5ECE}"/>
                </a:ext>
              </a:extLst>
            </p:cNvPr>
            <p:cNvSpPr/>
            <p:nvPr/>
          </p:nvSpPr>
          <p:spPr>
            <a:xfrm>
              <a:off x="131794" y="1635316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1260AE2E-56C5-4600-9944-D7E964D9B131}"/>
                </a:ext>
              </a:extLst>
            </p:cNvPr>
            <p:cNvSpPr/>
            <p:nvPr/>
          </p:nvSpPr>
          <p:spPr>
            <a:xfrm>
              <a:off x="1662201" y="1532115"/>
              <a:ext cx="2154011" cy="138331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000" b="1" dirty="0"/>
                <a:t>Keep all doors open to minimize contact with handles</a:t>
              </a:r>
              <a:endParaRPr lang="en-CA" sz="2000" b="1" dirty="0"/>
            </a:p>
          </p:txBody>
        </p:sp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FAF6551B-EEC9-4C4D-9253-5F91DD4C3D5C}"/>
                </a:ext>
              </a:extLst>
            </p:cNvPr>
            <p:cNvPicPr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79482" y="1797989"/>
              <a:ext cx="937152" cy="989003"/>
            </a:xfrm>
            <a:prstGeom prst="rect">
              <a:avLst/>
            </a:prstGeom>
          </p:spPr>
        </p:pic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562C06ED-DB33-4C96-AEC8-274D7BEBAB91}"/>
                </a:ext>
              </a:extLst>
            </p:cNvPr>
            <p:cNvSpPr/>
            <p:nvPr/>
          </p:nvSpPr>
          <p:spPr>
            <a:xfrm>
              <a:off x="5400467" y="1552031"/>
              <a:ext cx="2145959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000" b="1" dirty="0"/>
                <a:t>No touch trash bins with disposable linings</a:t>
              </a:r>
              <a:endParaRPr lang="en-CA" sz="2000" b="1" dirty="0"/>
            </a:p>
          </p:txBody>
        </p: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B28BE4F6-58EB-4381-861D-36BB7FFF2B0B}"/>
                </a:ext>
              </a:extLst>
            </p:cNvPr>
            <p:cNvGrpSpPr/>
            <p:nvPr/>
          </p:nvGrpSpPr>
          <p:grpSpPr>
            <a:xfrm>
              <a:off x="3870060" y="1627379"/>
              <a:ext cx="1487265" cy="1335307"/>
              <a:chOff x="4257602" y="2132769"/>
              <a:chExt cx="1487265" cy="1335307"/>
            </a:xfrm>
          </p:grpSpPr>
          <p:sp>
            <p:nvSpPr>
              <p:cNvPr id="108" name="Oval 107">
                <a:extLst>
                  <a:ext uri="{FF2B5EF4-FFF2-40B4-BE49-F238E27FC236}">
                    <a16:creationId xmlns:a16="http://schemas.microsoft.com/office/drawing/2014/main" id="{5B223977-D07E-4F22-B572-7F76D70CB3E4}"/>
                  </a:ext>
                </a:extLst>
              </p:cNvPr>
              <p:cNvSpPr/>
              <p:nvPr/>
            </p:nvSpPr>
            <p:spPr>
              <a:xfrm>
                <a:off x="4257602" y="2132769"/>
                <a:ext cx="1487265" cy="1335307"/>
              </a:xfrm>
              <a:prstGeom prst="ellipse">
                <a:avLst/>
              </a:prstGeom>
              <a:solidFill>
                <a:schemeClr val="bg1">
                  <a:lumMod val="95000"/>
                </a:schemeClr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b="1" dirty="0"/>
              </a:p>
            </p:txBody>
          </p:sp>
          <p:pic>
            <p:nvPicPr>
              <p:cNvPr id="109" name="Picture 108">
                <a:extLst>
                  <a:ext uri="{FF2B5EF4-FFF2-40B4-BE49-F238E27FC236}">
                    <a16:creationId xmlns:a16="http://schemas.microsoft.com/office/drawing/2014/main" id="{3D83ABD7-D81E-403D-8A56-6EF18CAFFCFB}"/>
                  </a:ext>
                </a:extLst>
              </p:cNvPr>
              <p:cNvPicPr>
                <a:picLocks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4557673" y="2392632"/>
                <a:ext cx="887447" cy="837229"/>
              </a:xfrm>
              <a:prstGeom prst="rect">
                <a:avLst/>
              </a:prstGeom>
            </p:spPr>
          </p:pic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C05ED32B-35CA-4332-84DB-C60744966FBD}"/>
              </a:ext>
            </a:extLst>
          </p:cNvPr>
          <p:cNvGrpSpPr/>
          <p:nvPr/>
        </p:nvGrpSpPr>
        <p:grpSpPr>
          <a:xfrm>
            <a:off x="3925373" y="5544718"/>
            <a:ext cx="1489158" cy="1338737"/>
            <a:chOff x="3967020" y="5278431"/>
            <a:chExt cx="1489158" cy="1338737"/>
          </a:xfrm>
        </p:grpSpPr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33A3260F-1F9A-4629-ACFD-8808F919DFEC}"/>
                </a:ext>
              </a:extLst>
            </p:cNvPr>
            <p:cNvSpPr/>
            <p:nvPr/>
          </p:nvSpPr>
          <p:spPr>
            <a:xfrm>
              <a:off x="3968913" y="5281861"/>
              <a:ext cx="1487265" cy="1335307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b="1"/>
            </a:p>
          </p:txBody>
        </p:sp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B89712A2-D5FA-42DE-951B-2563EAEC65A3}"/>
                </a:ext>
              </a:extLst>
            </p:cNvPr>
            <p:cNvGrpSpPr/>
            <p:nvPr/>
          </p:nvGrpSpPr>
          <p:grpSpPr>
            <a:xfrm>
              <a:off x="3967020" y="5278431"/>
              <a:ext cx="1481938" cy="1335324"/>
              <a:chOff x="6697396" y="2858135"/>
              <a:chExt cx="3809999" cy="3810000"/>
            </a:xfrm>
          </p:grpSpPr>
          <p:pic>
            <p:nvPicPr>
              <p:cNvPr id="112" name="Picture 111">
                <a:extLst>
                  <a:ext uri="{FF2B5EF4-FFF2-40B4-BE49-F238E27FC236}">
                    <a16:creationId xmlns:a16="http://schemas.microsoft.com/office/drawing/2014/main" id="{7F9B9D67-14FB-4086-8457-554B4A73FE1B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7459628" y="3642416"/>
                <a:ext cx="2562650" cy="2340570"/>
              </a:xfrm>
              <a:prstGeom prst="rect">
                <a:avLst/>
              </a:prstGeom>
            </p:spPr>
          </p:pic>
          <p:pic>
            <p:nvPicPr>
              <p:cNvPr id="113" name="Picture 112">
                <a:extLst>
                  <a:ext uri="{FF2B5EF4-FFF2-40B4-BE49-F238E27FC236}">
                    <a16:creationId xmlns:a16="http://schemas.microsoft.com/office/drawing/2014/main" id="{C6DF888A-1CCA-4089-A3BA-53344C4AD67F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6697396" y="2858135"/>
                <a:ext cx="3809999" cy="38100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7776669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B58952B9-AC08-440C-B92C-5D2639095C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8797160"/>
              </p:ext>
            </p:extLst>
          </p:nvPr>
        </p:nvGraphicFramePr>
        <p:xfrm>
          <a:off x="222852" y="152400"/>
          <a:ext cx="7226814" cy="9015586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1418460">
                  <a:extLst>
                    <a:ext uri="{9D8B030D-6E8A-4147-A177-3AD203B41FA5}">
                      <a16:colId xmlns:a16="http://schemas.microsoft.com/office/drawing/2014/main" val="2574916788"/>
                    </a:ext>
                  </a:extLst>
                </a:gridCol>
                <a:gridCol w="851077">
                  <a:extLst>
                    <a:ext uri="{9D8B030D-6E8A-4147-A177-3AD203B41FA5}">
                      <a16:colId xmlns:a16="http://schemas.microsoft.com/office/drawing/2014/main" val="501543107"/>
                    </a:ext>
                  </a:extLst>
                </a:gridCol>
                <a:gridCol w="1773076">
                  <a:extLst>
                    <a:ext uri="{9D8B030D-6E8A-4147-A177-3AD203B41FA5}">
                      <a16:colId xmlns:a16="http://schemas.microsoft.com/office/drawing/2014/main" val="2100964731"/>
                    </a:ext>
                  </a:extLst>
                </a:gridCol>
                <a:gridCol w="3184201">
                  <a:extLst>
                    <a:ext uri="{9D8B030D-6E8A-4147-A177-3AD203B41FA5}">
                      <a16:colId xmlns:a16="http://schemas.microsoft.com/office/drawing/2014/main" val="2905825357"/>
                    </a:ext>
                  </a:extLst>
                </a:gridCol>
              </a:tblGrid>
              <a:tr h="761869">
                <a:tc gridSpan="4">
                  <a:txBody>
                    <a:bodyPr/>
                    <a:lstStyle/>
                    <a:p>
                      <a:pPr algn="l"/>
                      <a:r>
                        <a:rPr lang="en-CA" sz="2200" dirty="0">
                          <a:solidFill>
                            <a:schemeClr val="tx1"/>
                          </a:solidFill>
                        </a:rPr>
                        <a:t>      Recommendations for Personal Protective </a:t>
                      </a:r>
                    </a:p>
                    <a:p>
                      <a:pPr algn="l"/>
                      <a:r>
                        <a:rPr lang="en-CA" sz="2200" dirty="0">
                          <a:solidFill>
                            <a:schemeClr val="tx1"/>
                          </a:solidFill>
                        </a:rPr>
                        <a:t>          Equipment in the Otolaryngology Clinic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 sz="120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 sz="120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5316075"/>
                  </a:ext>
                </a:extLst>
              </a:tr>
              <a:tr h="463194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Encounter Type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Possible AGMP ?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Physician PPE*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Special Considerations 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782200543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History</a:t>
                      </a:r>
                      <a:r>
                        <a:rPr lang="en-CA" sz="1400" dirty="0"/>
                        <a:t>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50000"/>
                        </a:lnSpc>
                      </a:pPr>
                      <a:r>
                        <a:rPr lang="en-CA" sz="1400" dirty="0"/>
                        <a:t>Minimal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ctr">
                        <a:buFont typeface="Arial" panose="020B0604020202020204" pitchFamily="34" charset="0"/>
                        <a:buNone/>
                      </a:pPr>
                      <a:r>
                        <a:rPr lang="en-CA" sz="1400" dirty="0"/>
                        <a:t>Surgical Mask, </a:t>
                      </a:r>
                    </a:p>
                    <a:p>
                      <a:pPr marL="0" indent="0" algn="ctr">
                        <a:buFont typeface="Arial" panose="020B0604020202020204" pitchFamily="34" charset="0"/>
                        <a:buNone/>
                      </a:pPr>
                      <a:r>
                        <a:rPr lang="en-CA" sz="1400" dirty="0"/>
                        <a:t>Eye Protection**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indent="0" algn="ctr">
                        <a:buFont typeface="Arial" panose="020B0604020202020204" pitchFamily="34" charset="0"/>
                        <a:buNone/>
                      </a:pPr>
                      <a:r>
                        <a:rPr lang="en-CA" sz="1400" dirty="0"/>
                        <a:t>Consider virtual Hx to minimize in-person time </a:t>
                      </a:r>
                    </a:p>
                    <a:p>
                      <a:pPr marL="0" indent="0" algn="ctr">
                        <a:buFont typeface="Arial" panose="020B0604020202020204" pitchFamily="34" charset="0"/>
                        <a:buNone/>
                      </a:pPr>
                      <a:r>
                        <a:rPr lang="en-CA" sz="1400" dirty="0"/>
                        <a:t>Maintain physical distancing in person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800240412"/>
                  </a:ext>
                </a:extLst>
              </a:tr>
              <a:tr h="128256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Physical Exam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50000"/>
                        </a:lnSpc>
                      </a:pPr>
                      <a:r>
                        <a:rPr lang="en-CA" sz="1400" dirty="0"/>
                        <a:t>`Minimal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dirty="0"/>
                        <a:t>Surgical Mask, </a:t>
                      </a:r>
                    </a:p>
                    <a:p>
                      <a:pPr algn="ctr"/>
                      <a:r>
                        <a:rPr lang="en-CA" sz="1400" dirty="0"/>
                        <a:t>Eye protection** </a:t>
                      </a:r>
                    </a:p>
                    <a:p>
                      <a:pPr algn="ctr"/>
                      <a:r>
                        <a:rPr lang="en-CA" sz="1400" dirty="0"/>
                        <a:t>Gloves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dirty="0"/>
                        <a:t>Only remove mask off patient when necessary for exam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3884527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Otologic Procedures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50000"/>
                        </a:lnSpc>
                      </a:pPr>
                      <a:r>
                        <a:rPr lang="en-CA" sz="1400" dirty="0"/>
                        <a:t>Minimal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dirty="0"/>
                        <a:t>Surgical Mask, </a:t>
                      </a:r>
                    </a:p>
                    <a:p>
                      <a:pPr algn="ctr"/>
                      <a:r>
                        <a:rPr lang="en-CA" sz="1400" dirty="0"/>
                        <a:t>Eye Protection**, </a:t>
                      </a:r>
                    </a:p>
                    <a:p>
                      <a:pPr algn="ctr"/>
                      <a:r>
                        <a:rPr lang="en-CA" sz="1400" dirty="0"/>
                        <a:t>Gloves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IT injections, Tube Placement, Mastoid/EAC Debridement </a:t>
                      </a:r>
                    </a:p>
                    <a:p>
                      <a:pPr algn="ctr"/>
                      <a:r>
                        <a:rPr lang="en-CA" sz="1400" dirty="0"/>
                        <a:t>Beware Arnold’s reflex </a:t>
                      </a:r>
                    </a:p>
                    <a:p>
                      <a:pPr algn="ctr"/>
                      <a:r>
                        <a:rPr lang="en-CA" sz="1400" dirty="0"/>
                        <a:t>Consider local blocks to reduce coughing for extensive debridement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407967794"/>
                  </a:ext>
                </a:extLst>
              </a:tr>
              <a:tr h="441960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Cauterization </a:t>
                      </a:r>
                    </a:p>
                    <a:p>
                      <a:pPr algn="ctr"/>
                      <a:r>
                        <a:rPr lang="en-CA" sz="1400" b="1" dirty="0"/>
                        <a:t>Epistaxis</a:t>
                      </a:r>
                    </a:p>
                    <a:p>
                      <a:pPr algn="ctr"/>
                      <a:endParaRPr lang="en-CA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50000"/>
                        </a:lnSpc>
                      </a:pPr>
                      <a:r>
                        <a:rPr lang="en-CA" sz="1400" dirty="0"/>
                        <a:t>Minimal </a:t>
                      </a: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endParaRPr lang="en-CA" sz="1400" dirty="0"/>
                    </a:p>
                    <a:p>
                      <a:pPr algn="ctr"/>
                      <a:r>
                        <a:rPr lang="en-CA" sz="1400" dirty="0"/>
                        <a:t>Surgical Mask, Eye Protection, Gloves, Gown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dirty="0"/>
                        <a:t>Consider chemical cauterization over electrocautery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306631609"/>
                  </a:ext>
                </a:extLst>
              </a:tr>
              <a:tr h="254063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Rigid Nasal Endoscopy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50000"/>
                        </a:lnSpc>
                      </a:pPr>
                      <a:r>
                        <a:rPr lang="en-CA" sz="1300" dirty="0"/>
                        <a:t>Moderate 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endParaRPr lang="en-CA" sz="1400" dirty="0"/>
                    </a:p>
                    <a:p>
                      <a:pPr algn="ctr"/>
                      <a:r>
                        <a:rPr lang="en-CA" sz="1400" dirty="0"/>
                        <a:t>Avoid powered aerosolized anesthetic sprays </a:t>
                      </a:r>
                    </a:p>
                    <a:p>
                      <a:pPr algn="ctr"/>
                      <a:r>
                        <a:rPr lang="en-CA" sz="1400" dirty="0"/>
                        <a:t>Pull mask down to expose nostril or modify mask, keep mouth covered </a:t>
                      </a:r>
                    </a:p>
                    <a:p>
                      <a:pPr algn="ctr"/>
                      <a:r>
                        <a:rPr lang="en-CA" sz="1400" dirty="0"/>
                        <a:t>Consider video system over direct visualization to increase distance from patient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28590059"/>
                  </a:ext>
                </a:extLst>
              </a:tr>
              <a:tr h="1109146">
                <a:tc>
                  <a:txBody>
                    <a:bodyPr/>
                    <a:lstStyle/>
                    <a:p>
                      <a:pPr algn="ctr"/>
                      <a:endParaRPr lang="en-CA" sz="1400" b="1" dirty="0"/>
                    </a:p>
                    <a:p>
                      <a:pPr algn="ctr"/>
                      <a:endParaRPr lang="en-CA" sz="1400" b="1" dirty="0"/>
                    </a:p>
                    <a:p>
                      <a:pPr algn="ctr"/>
                      <a:r>
                        <a:rPr lang="en-CA" sz="1400" b="1" dirty="0"/>
                        <a:t>Flexible NP scope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300" dirty="0"/>
                        <a:t>Moderate 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CA" sz="12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CA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7753929"/>
                  </a:ext>
                </a:extLst>
              </a:tr>
              <a:tr h="494582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Tracheostomy/</a:t>
                      </a:r>
                    </a:p>
                    <a:p>
                      <a:pPr algn="ctr"/>
                      <a:r>
                        <a:rPr lang="en-CA" sz="1400" b="1" dirty="0"/>
                        <a:t>Laryngectomy Patient</a:t>
                      </a:r>
                    </a:p>
                    <a:p>
                      <a:pPr algn="ctr"/>
                      <a:endParaRPr lang="en-CA" sz="1400" b="1" dirty="0"/>
                    </a:p>
                    <a:p>
                      <a:pPr algn="ctr"/>
                      <a:endParaRPr lang="en-CA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CA" sz="1400" dirty="0"/>
                        <a:t>High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CA" sz="1400" dirty="0"/>
                    </a:p>
                    <a:p>
                      <a:pPr algn="ctr"/>
                      <a:r>
                        <a:rPr lang="en-CA" sz="1400" dirty="0"/>
                        <a:t>N95 Respirator or Surgical Mask, Eye Protection, Gloves, Gown </a:t>
                      </a:r>
                    </a:p>
                    <a:p>
                      <a:pPr algn="ctr"/>
                      <a:endParaRPr lang="en-CA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dirty="0"/>
                        <a:t>Unable to cover cough </a:t>
                      </a:r>
                    </a:p>
                    <a:p>
                      <a:pPr algn="ctr"/>
                      <a:r>
                        <a:rPr lang="en-CA" sz="1400" dirty="0"/>
                        <a:t>Consider N95 mask, particularly if tube being manipulated or suctioning performed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423493484"/>
                  </a:ext>
                </a:extLst>
              </a:tr>
              <a:tr h="613051">
                <a:tc>
                  <a:txBody>
                    <a:bodyPr/>
                    <a:lstStyle/>
                    <a:p>
                      <a:pPr algn="ctr"/>
                      <a:r>
                        <a:rPr lang="en-CA" sz="1400" b="1" dirty="0"/>
                        <a:t>Rigid Laryngoscopy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300" dirty="0"/>
                        <a:t>No consensu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dirty="0"/>
                        <a:t>No consensus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400" dirty="0"/>
                        <a:t>Consider flexible nasopharyngoscopy as alternative 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863185020"/>
                  </a:ext>
                </a:extLst>
              </a:tr>
              <a:tr h="526906">
                <a:tc gridSpan="4">
                  <a:txBody>
                    <a:bodyPr/>
                    <a:lstStyle/>
                    <a:p>
                      <a:pPr marL="0" indent="0" algn="l">
                        <a:buFont typeface="Arial" panose="020B0604020202020204" pitchFamily="34" charset="0"/>
                        <a:buNone/>
                      </a:pPr>
                      <a:r>
                        <a:rPr lang="en-CA" sz="1400" dirty="0"/>
                        <a:t>*Minimum recommended personal protective equipment </a:t>
                      </a:r>
                    </a:p>
                    <a:p>
                      <a:pPr marL="0" indent="0" algn="l">
                        <a:buFont typeface="Arial" panose="020B0604020202020204" pitchFamily="34" charset="0"/>
                        <a:buNone/>
                      </a:pPr>
                      <a:r>
                        <a:rPr lang="en-CA" sz="1400" dirty="0"/>
                        <a:t>** optional PPE at physician discretion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1337870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AA016AC9-DB69-4521-8A14-6F7B2868AB67}"/>
              </a:ext>
            </a:extLst>
          </p:cNvPr>
          <p:cNvSpPr/>
          <p:nvPr/>
        </p:nvSpPr>
        <p:spPr>
          <a:xfrm>
            <a:off x="191321" y="9115877"/>
            <a:ext cx="3886200" cy="26161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CA" sz="1100" dirty="0"/>
              <a:t>Version Date: May 24, 2020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F11A146-A7C2-4BC7-9AB7-3BEAC8162749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82111" y="1533472"/>
            <a:ext cx="493540" cy="65363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68E58F9-C297-462D-B3A2-0CFC76BAF755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52525" y="3401970"/>
            <a:ext cx="338918" cy="42770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ABC2D91-573E-4D00-8338-6238F0163E14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196911" y="6064193"/>
            <a:ext cx="422791" cy="380311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42A0E1CA-5ACA-4AC6-B935-4794DF4C5CB9}"/>
              </a:ext>
            </a:extLst>
          </p:cNvPr>
          <p:cNvGrpSpPr/>
          <p:nvPr/>
        </p:nvGrpSpPr>
        <p:grpSpPr>
          <a:xfrm>
            <a:off x="585981" y="7146584"/>
            <a:ext cx="685800" cy="826169"/>
            <a:chOff x="551113" y="1310640"/>
            <a:chExt cx="3810000" cy="3810000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4772EF4C-CB70-493A-8338-283CC494A9A3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51113" y="1310640"/>
              <a:ext cx="3810000" cy="381000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4EC4D481-50CA-47C6-8514-868333833E92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800000">
              <a:off x="1999796" y="3279201"/>
              <a:ext cx="912633" cy="66556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D2B70A89-DAC1-48DA-8E1B-A923AD244875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 rot="9689111">
              <a:off x="2085887" y="3723161"/>
              <a:ext cx="798505" cy="935212"/>
            </a:xfrm>
            <a:prstGeom prst="rect">
              <a:avLst/>
            </a:prstGeom>
          </p:spPr>
        </p:pic>
      </p:grpSp>
      <p:pic>
        <p:nvPicPr>
          <p:cNvPr id="26" name="Picture 2" descr="Canadian Society of Otolaryngology 73rd Annual Meeting - Edmonton ...">
            <a:extLst>
              <a:ext uri="{FF2B5EF4-FFF2-40B4-BE49-F238E27FC236}">
                <a16:creationId xmlns:a16="http://schemas.microsoft.com/office/drawing/2014/main" id="{54F2B3CB-B4F3-485D-BCC9-41980C84D4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8711" y="9167986"/>
            <a:ext cx="2139348" cy="5387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5EA876C-E8FC-40A2-BA32-9156CD89DBAC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540984" y="5317858"/>
            <a:ext cx="590550" cy="412458"/>
          </a:xfrm>
          <a:prstGeom prst="rect">
            <a:avLst/>
          </a:prstGeom>
        </p:spPr>
      </p:pic>
      <p:grpSp>
        <p:nvGrpSpPr>
          <p:cNvPr id="30" name="Group 29">
            <a:extLst>
              <a:ext uri="{FF2B5EF4-FFF2-40B4-BE49-F238E27FC236}">
                <a16:creationId xmlns:a16="http://schemas.microsoft.com/office/drawing/2014/main" id="{F12A2679-218B-402F-BB68-A2E8DCE927B3}"/>
              </a:ext>
            </a:extLst>
          </p:cNvPr>
          <p:cNvGrpSpPr/>
          <p:nvPr/>
        </p:nvGrpSpPr>
        <p:grpSpPr>
          <a:xfrm>
            <a:off x="2514787" y="5073381"/>
            <a:ext cx="1131982" cy="1180968"/>
            <a:chOff x="2917523" y="4929303"/>
            <a:chExt cx="1446505" cy="1544688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5A54B91A-7501-4C68-877E-7BCEFAEA9550}"/>
                </a:ext>
              </a:extLst>
            </p:cNvPr>
            <p:cNvGrpSpPr/>
            <p:nvPr/>
          </p:nvGrpSpPr>
          <p:grpSpPr>
            <a:xfrm>
              <a:off x="3185291" y="4929303"/>
              <a:ext cx="914400" cy="819618"/>
              <a:chOff x="9810226" y="3586001"/>
              <a:chExt cx="2895611" cy="2701382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BB668E98-201D-4F00-9483-008B018DC749}"/>
                  </a:ext>
                </a:extLst>
              </p:cNvPr>
              <p:cNvGrpSpPr/>
              <p:nvPr/>
            </p:nvGrpSpPr>
            <p:grpSpPr>
              <a:xfrm>
                <a:off x="9810226" y="3586001"/>
                <a:ext cx="2895611" cy="2701382"/>
                <a:chOff x="14437305" y="1724101"/>
                <a:chExt cx="3810000" cy="3810000"/>
              </a:xfrm>
            </p:grpSpPr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4A194B26-9ED5-4B81-8D36-CC5DC326D17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15057019" y="1724101"/>
                  <a:ext cx="2570571" cy="2701382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67558A9B-8623-419E-94D8-475E58F80BC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4437305" y="1724101"/>
                  <a:ext cx="3810000" cy="3810000"/>
                </a:xfrm>
                <a:prstGeom prst="rect">
                  <a:avLst/>
                </a:prstGeom>
              </p:spPr>
            </p:pic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346DB8FA-22A2-4C81-BDA2-281D5D1FE698}"/>
                    </a:ext>
                  </a:extLst>
                </p:cNvPr>
                <p:cNvGrpSpPr/>
                <p:nvPr/>
              </p:nvGrpSpPr>
              <p:grpSpPr>
                <a:xfrm>
                  <a:off x="15770804" y="3030104"/>
                  <a:ext cx="1143000" cy="1197993"/>
                  <a:chOff x="12649200" y="3564507"/>
                  <a:chExt cx="1143000" cy="1197993"/>
                </a:xfrm>
              </p:grpSpPr>
              <p:sp>
                <p:nvSpPr>
                  <p:cNvPr id="17" name="Oval 16">
                    <a:extLst>
                      <a:ext uri="{FF2B5EF4-FFF2-40B4-BE49-F238E27FC236}">
                        <a16:creationId xmlns:a16="http://schemas.microsoft.com/office/drawing/2014/main" id="{1778EB2D-C9E6-43D5-80A3-3356AE2F5B02}"/>
                      </a:ext>
                    </a:extLst>
                  </p:cNvPr>
                  <p:cNvSpPr/>
                  <p:nvPr/>
                </p:nvSpPr>
                <p:spPr>
                  <a:xfrm>
                    <a:off x="12649200" y="3564507"/>
                    <a:ext cx="1143000" cy="1197993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/>
                  </a:p>
                </p:txBody>
              </p:sp>
              <p:cxnSp>
                <p:nvCxnSpPr>
                  <p:cNvPr id="18" name="Straight Connector 17">
                    <a:extLst>
                      <a:ext uri="{FF2B5EF4-FFF2-40B4-BE49-F238E27FC236}">
                        <a16:creationId xmlns:a16="http://schemas.microsoft.com/office/drawing/2014/main" id="{4BF1B324-8BA5-4CF8-ACDC-F28E905B7103}"/>
                      </a:ext>
                    </a:extLst>
                  </p:cNvPr>
                  <p:cNvCxnSpPr/>
                  <p:nvPr/>
                </p:nvCxnSpPr>
                <p:spPr>
                  <a:xfrm>
                    <a:off x="12954000" y="3894696"/>
                    <a:ext cx="4572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Connector 18">
                    <a:extLst>
                      <a:ext uri="{FF2B5EF4-FFF2-40B4-BE49-F238E27FC236}">
                        <a16:creationId xmlns:a16="http://schemas.microsoft.com/office/drawing/2014/main" id="{E68AB816-91B8-4D09-AC98-C2BC6D60D4DA}"/>
                      </a:ext>
                    </a:extLst>
                  </p:cNvPr>
                  <p:cNvCxnSpPr/>
                  <p:nvPr/>
                </p:nvCxnSpPr>
                <p:spPr>
                  <a:xfrm>
                    <a:off x="12954000" y="4474206"/>
                    <a:ext cx="4572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Connector 19">
                    <a:extLst>
                      <a:ext uri="{FF2B5EF4-FFF2-40B4-BE49-F238E27FC236}">
                        <a16:creationId xmlns:a16="http://schemas.microsoft.com/office/drawing/2014/main" id="{690B5977-56AE-443D-BB20-87E51B2AD0C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877800" y="4076700"/>
                    <a:ext cx="6858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Connector 20">
                    <a:extLst>
                      <a:ext uri="{FF2B5EF4-FFF2-40B4-BE49-F238E27FC236}">
                        <a16:creationId xmlns:a16="http://schemas.microsoft.com/office/drawing/2014/main" id="{C81F692F-88CE-4D22-AE23-FC2DC7723F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787312" y="4305300"/>
                    <a:ext cx="852488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3" name="Rectangle: Top Corners Snipped 12">
                <a:extLst>
                  <a:ext uri="{FF2B5EF4-FFF2-40B4-BE49-F238E27FC236}">
                    <a16:creationId xmlns:a16="http://schemas.microsoft.com/office/drawing/2014/main" id="{375BA502-67B8-43BB-95FD-0756344B3C6D}"/>
                  </a:ext>
                </a:extLst>
              </p:cNvPr>
              <p:cNvSpPr/>
              <p:nvPr/>
            </p:nvSpPr>
            <p:spPr>
              <a:xfrm>
                <a:off x="10649565" y="3882102"/>
                <a:ext cx="1219200" cy="1515676"/>
              </a:xfrm>
              <a:prstGeom prst="snip2Same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79F1B9AE-BF96-436D-A046-849202E55629}"/>
                </a:ext>
              </a:extLst>
            </p:cNvPr>
            <p:cNvPicPr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917523" y="5328018"/>
              <a:ext cx="1446505" cy="1145973"/>
            </a:xfrm>
            <a:prstGeom prst="rect">
              <a:avLst/>
            </a:prstGeom>
          </p:spPr>
        </p:pic>
      </p:grpSp>
      <p:pic>
        <p:nvPicPr>
          <p:cNvPr id="34" name="Picture 33">
            <a:extLst>
              <a:ext uri="{FF2B5EF4-FFF2-40B4-BE49-F238E27FC236}">
                <a16:creationId xmlns:a16="http://schemas.microsoft.com/office/drawing/2014/main" id="{E2C10178-E6B8-4E56-B58B-98B3340264DC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703371" y="2374648"/>
            <a:ext cx="493540" cy="427705"/>
          </a:xfrm>
          <a:prstGeom prst="rect">
            <a:avLst/>
          </a:prstGeom>
        </p:spPr>
      </p:pic>
      <p:grpSp>
        <p:nvGrpSpPr>
          <p:cNvPr id="50" name="Group 49">
            <a:extLst>
              <a:ext uri="{FF2B5EF4-FFF2-40B4-BE49-F238E27FC236}">
                <a16:creationId xmlns:a16="http://schemas.microsoft.com/office/drawing/2014/main" id="{3F14804B-0A7F-4D1D-AB1D-D0783CB6485D}"/>
              </a:ext>
            </a:extLst>
          </p:cNvPr>
          <p:cNvGrpSpPr/>
          <p:nvPr/>
        </p:nvGrpSpPr>
        <p:grpSpPr>
          <a:xfrm>
            <a:off x="335841" y="5460776"/>
            <a:ext cx="698721" cy="156082"/>
            <a:chOff x="-2540977" y="5248194"/>
            <a:chExt cx="3481536" cy="934619"/>
          </a:xfrm>
        </p:grpSpPr>
        <p:sp>
          <p:nvSpPr>
            <p:cNvPr id="37" name="Isosceles Triangle 36">
              <a:extLst>
                <a:ext uri="{FF2B5EF4-FFF2-40B4-BE49-F238E27FC236}">
                  <a16:creationId xmlns:a16="http://schemas.microsoft.com/office/drawing/2014/main" id="{D5BE0586-33F2-46B2-8538-E22138A9804E}"/>
                </a:ext>
              </a:extLst>
            </p:cNvPr>
            <p:cNvSpPr/>
            <p:nvPr/>
          </p:nvSpPr>
          <p:spPr>
            <a:xfrm rot="19806143">
              <a:off x="-2540977" y="5248194"/>
              <a:ext cx="685800" cy="61920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8D4CC1E2-6E67-4D96-A175-269BB6DCA0BE}"/>
                </a:ext>
              </a:extLst>
            </p:cNvPr>
            <p:cNvSpPr/>
            <p:nvPr/>
          </p:nvSpPr>
          <p:spPr>
            <a:xfrm>
              <a:off x="-2084852" y="5430526"/>
              <a:ext cx="179852" cy="44429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09373831-20FD-483E-843A-770CE2E51C9F}"/>
                </a:ext>
              </a:extLst>
            </p:cNvPr>
            <p:cNvSpPr/>
            <p:nvPr/>
          </p:nvSpPr>
          <p:spPr>
            <a:xfrm>
              <a:off x="-1720111" y="5738519"/>
              <a:ext cx="163760" cy="44429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49" name="Rectangle: Rounded Corners 48">
              <a:extLst>
                <a:ext uri="{FF2B5EF4-FFF2-40B4-BE49-F238E27FC236}">
                  <a16:creationId xmlns:a16="http://schemas.microsoft.com/office/drawing/2014/main" id="{E11FA2F0-A87A-4DC0-9036-4FD5141B80CC}"/>
                </a:ext>
              </a:extLst>
            </p:cNvPr>
            <p:cNvSpPr/>
            <p:nvPr/>
          </p:nvSpPr>
          <p:spPr>
            <a:xfrm>
              <a:off x="-1905000" y="5557797"/>
              <a:ext cx="2845559" cy="180722"/>
            </a:xfrm>
            <a:prstGeom prst="round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pic>
        <p:nvPicPr>
          <p:cNvPr id="59" name="Picture 58">
            <a:extLst>
              <a:ext uri="{FF2B5EF4-FFF2-40B4-BE49-F238E27FC236}">
                <a16:creationId xmlns:a16="http://schemas.microsoft.com/office/drawing/2014/main" id="{38BA9BF8-774A-487F-B5C5-63777DD696FF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1007731" y="5153855"/>
            <a:ext cx="678333" cy="590905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72365F87-AD0A-416D-90E2-D473E533B3A4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6479874" y="152400"/>
            <a:ext cx="880940" cy="7640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0925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438" row="17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4D3F057-8796-495B-AFE2-8CC4CCBFA7CD}">
  <we:reference id="wa104381063" version="1.0.0.1" store="en-US" storeType="OMEX"/>
  <we:alternateReferences>
    <we:reference id="wa104381063" version="1.0.0.1" store="en-US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8378</TotalTime>
  <Words>480</Words>
  <Application>Microsoft Office PowerPoint</Application>
  <PresentationFormat>Custom</PresentationFormat>
  <Paragraphs>9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Calibri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nergy-Based Devices JAMA Surgery 2019</dc:title>
  <dc:creator>Williams, Wendy</dc:creator>
  <cp:lastModifiedBy>Jennifer Siu</cp:lastModifiedBy>
  <cp:revision>107</cp:revision>
  <cp:lastPrinted>2020-06-01T13:32:32Z</cp:lastPrinted>
  <dcterms:created xsi:type="dcterms:W3CDTF">2006-08-16T00:00:00Z</dcterms:created>
  <dcterms:modified xsi:type="dcterms:W3CDTF">2020-09-30T15:12:07Z</dcterms:modified>
  <dc:identifier>DADb0e7S_o8</dc:identifier>
</cp:coreProperties>
</file>